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7200900" cy="1692275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5330">
          <p15:clr>
            <a:srgbClr val="A4A3A4"/>
          </p15:clr>
        </p15:guide>
        <p15:guide id="2" pos="22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80A0E3D-4327-47AD-AF4E-C5A9CC23AC99}" v="97" dt="2024-02-26T00:41:56.8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276" autoAdjust="0"/>
    <p:restoredTop sz="94660"/>
  </p:normalViewPr>
  <p:slideViewPr>
    <p:cSldViewPr>
      <p:cViewPr>
        <p:scale>
          <a:sx n="40" d="100"/>
          <a:sy n="40" d="100"/>
        </p:scale>
        <p:origin x="-4254" y="-372"/>
      </p:cViewPr>
      <p:guideLst>
        <p:guide orient="horz" pos="5330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5/10/relationships/revisionInfo" Target="revisionInfo.xml"/><Relationship Id="rId4" Type="http://schemas.openxmlformats.org/officeDocument/2006/relationships/presProps" Target="presProps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ominik Aumann" userId="013c187a20e8f01a" providerId="LiveId" clId="{C80A0E3D-4327-47AD-AF4E-C5A9CC23AC99}"/>
    <pc:docChg chg="undo redo custSel addSld delSld modSld sldOrd">
      <pc:chgData name="Dominik Aumann" userId="013c187a20e8f01a" providerId="LiveId" clId="{C80A0E3D-4327-47AD-AF4E-C5A9CC23AC99}" dt="2024-02-26T00:42:11.217" v="1207" actId="1037"/>
      <pc:docMkLst>
        <pc:docMk/>
      </pc:docMkLst>
      <pc:sldChg chg="addSp delSp modSp mod">
        <pc:chgData name="Dominik Aumann" userId="013c187a20e8f01a" providerId="LiveId" clId="{C80A0E3D-4327-47AD-AF4E-C5A9CC23AC99}" dt="2024-02-26T00:10:38.564" v="388" actId="478"/>
        <pc:sldMkLst>
          <pc:docMk/>
          <pc:sldMk cId="1111443064" sldId="256"/>
        </pc:sldMkLst>
        <pc:spChg chg="add mod">
          <ac:chgData name="Dominik Aumann" userId="013c187a20e8f01a" providerId="LiveId" clId="{C80A0E3D-4327-47AD-AF4E-C5A9CC23AC99}" dt="2024-02-25T23:54:26.212" v="94" actId="1076"/>
          <ac:spMkLst>
            <pc:docMk/>
            <pc:sldMk cId="1111443064" sldId="256"/>
            <ac:spMk id="67" creationId="{87070AD8-4954-84C3-8451-57A6790C8D7D}"/>
          </ac:spMkLst>
        </pc:spChg>
        <pc:picChg chg="add del mod">
          <ac:chgData name="Dominik Aumann" userId="013c187a20e8f01a" providerId="LiveId" clId="{C80A0E3D-4327-47AD-AF4E-C5A9CC23AC99}" dt="2024-02-25T23:54:01.124" v="79" actId="1076"/>
          <ac:picMkLst>
            <pc:docMk/>
            <pc:sldMk cId="1111443064" sldId="256"/>
            <ac:picMk id="2" creationId="{09B9F772-D821-675B-B346-DDCA60528223}"/>
          </ac:picMkLst>
        </pc:picChg>
        <pc:picChg chg="add mod ord">
          <ac:chgData name="Dominik Aumann" userId="013c187a20e8f01a" providerId="LiveId" clId="{C80A0E3D-4327-47AD-AF4E-C5A9CC23AC99}" dt="2024-02-25T23:53:58.125" v="75" actId="167"/>
          <ac:picMkLst>
            <pc:docMk/>
            <pc:sldMk cId="1111443064" sldId="256"/>
            <ac:picMk id="3" creationId="{09B9F772-D821-675B-B346-DDCA60528223}"/>
          </ac:picMkLst>
        </pc:picChg>
        <pc:picChg chg="add del">
          <ac:chgData name="Dominik Aumann" userId="013c187a20e8f01a" providerId="LiveId" clId="{C80A0E3D-4327-47AD-AF4E-C5A9CC23AC99}" dt="2024-02-25T23:53:58.125" v="76" actId="478"/>
          <ac:picMkLst>
            <pc:docMk/>
            <pc:sldMk cId="1111443064" sldId="256"/>
            <ac:picMk id="5" creationId="{00000000-0000-0000-0000-000000000000}"/>
          </ac:picMkLst>
        </pc:picChg>
        <pc:picChg chg="add del">
          <ac:chgData name="Dominik Aumann" userId="013c187a20e8f01a" providerId="LiveId" clId="{C80A0E3D-4327-47AD-AF4E-C5A9CC23AC99}" dt="2024-02-26T00:01:53.114" v="180" actId="21"/>
          <ac:picMkLst>
            <pc:docMk/>
            <pc:sldMk cId="1111443064" sldId="256"/>
            <ac:picMk id="33" creationId="{00000000-0000-0000-0000-000000000000}"/>
          </ac:picMkLst>
        </pc:picChg>
        <pc:picChg chg="add del mod">
          <ac:chgData name="Dominik Aumann" userId="013c187a20e8f01a" providerId="LiveId" clId="{C80A0E3D-4327-47AD-AF4E-C5A9CC23AC99}" dt="2024-02-26T00:10:38.564" v="388" actId="478"/>
          <ac:picMkLst>
            <pc:docMk/>
            <pc:sldMk cId="1111443064" sldId="256"/>
            <ac:picMk id="93" creationId="{310A52E4-CE42-2C3B-204D-DCD246EA8656}"/>
          </ac:picMkLst>
        </pc:picChg>
        <pc:cxnChg chg="mod">
          <ac:chgData name="Dominik Aumann" userId="013c187a20e8f01a" providerId="LiveId" clId="{C80A0E3D-4327-47AD-AF4E-C5A9CC23AC99}" dt="2024-02-25T23:53:58.125" v="74" actId="14100"/>
          <ac:cxnSpMkLst>
            <pc:docMk/>
            <pc:sldMk cId="1111443064" sldId="256"/>
            <ac:cxnSpMk id="66" creationId="{00000000-0000-0000-0000-000000000000}"/>
          </ac:cxnSpMkLst>
        </pc:cxnChg>
      </pc:sldChg>
      <pc:sldChg chg="addSp delSp modSp new del mod ord">
        <pc:chgData name="Dominik Aumann" userId="013c187a20e8f01a" providerId="LiveId" clId="{C80A0E3D-4327-47AD-AF4E-C5A9CC23AC99}" dt="2024-02-26T00:34:03.255" v="873" actId="47"/>
        <pc:sldMkLst>
          <pc:docMk/>
          <pc:sldMk cId="1136879520" sldId="257"/>
        </pc:sldMkLst>
        <pc:spChg chg="del">
          <ac:chgData name="Dominik Aumann" userId="013c187a20e8f01a" providerId="LiveId" clId="{C80A0E3D-4327-47AD-AF4E-C5A9CC23AC99}" dt="2024-02-25T23:50:40.164" v="1" actId="478"/>
          <ac:spMkLst>
            <pc:docMk/>
            <pc:sldMk cId="1136879520" sldId="257"/>
            <ac:spMk id="2" creationId="{1ED26DDB-64B9-80C8-0C88-C35368553886}"/>
          </ac:spMkLst>
        </pc:spChg>
        <pc:spChg chg="del">
          <ac:chgData name="Dominik Aumann" userId="013c187a20e8f01a" providerId="LiveId" clId="{C80A0E3D-4327-47AD-AF4E-C5A9CC23AC99}" dt="2024-02-25T23:50:40.164" v="1" actId="478"/>
          <ac:spMkLst>
            <pc:docMk/>
            <pc:sldMk cId="1136879520" sldId="257"/>
            <ac:spMk id="3" creationId="{020B90A0-B5DB-7E18-097B-C4EF8A8EDC11}"/>
          </ac:spMkLst>
        </pc:spChg>
        <pc:picChg chg="add del mod">
          <ac:chgData name="Dominik Aumann" userId="013c187a20e8f01a" providerId="LiveId" clId="{C80A0E3D-4327-47AD-AF4E-C5A9CC23AC99}" dt="2024-02-26T00:18:19.923" v="574" actId="21"/>
          <ac:picMkLst>
            <pc:docMk/>
            <pc:sldMk cId="1136879520" sldId="257"/>
            <ac:picMk id="5" creationId="{31C64126-B8C0-6E3A-F826-CDCCF94235C4}"/>
          </ac:picMkLst>
        </pc:picChg>
        <pc:picChg chg="add del mod">
          <ac:chgData name="Dominik Aumann" userId="013c187a20e8f01a" providerId="LiveId" clId="{C80A0E3D-4327-47AD-AF4E-C5A9CC23AC99}" dt="2024-02-26T00:18:07.645" v="569" actId="21"/>
          <ac:picMkLst>
            <pc:docMk/>
            <pc:sldMk cId="1136879520" sldId="257"/>
            <ac:picMk id="7" creationId="{16252424-273C-F778-8D80-5C0E79207338}"/>
          </ac:picMkLst>
        </pc:picChg>
        <pc:picChg chg="add del mod">
          <ac:chgData name="Dominik Aumann" userId="013c187a20e8f01a" providerId="LiveId" clId="{C80A0E3D-4327-47AD-AF4E-C5A9CC23AC99}" dt="2024-02-26T00:17:55.882" v="564" actId="21"/>
          <ac:picMkLst>
            <pc:docMk/>
            <pc:sldMk cId="1136879520" sldId="257"/>
            <ac:picMk id="9" creationId="{BF8DEC6E-77F0-447F-3FD9-386E94E0137B}"/>
          </ac:picMkLst>
        </pc:picChg>
        <pc:picChg chg="add del mod">
          <ac:chgData name="Dominik Aumann" userId="013c187a20e8f01a" providerId="LiveId" clId="{C80A0E3D-4327-47AD-AF4E-C5A9CC23AC99}" dt="2024-02-26T00:17:44.025" v="559" actId="21"/>
          <ac:picMkLst>
            <pc:docMk/>
            <pc:sldMk cId="1136879520" sldId="257"/>
            <ac:picMk id="11" creationId="{3958AC26-E1C6-B46F-A705-E3CD47FD6E53}"/>
          </ac:picMkLst>
        </pc:picChg>
        <pc:picChg chg="add del mod">
          <ac:chgData name="Dominik Aumann" userId="013c187a20e8f01a" providerId="LiveId" clId="{C80A0E3D-4327-47AD-AF4E-C5A9CC23AC99}" dt="2024-02-26T00:17:32.793" v="555" actId="21"/>
          <ac:picMkLst>
            <pc:docMk/>
            <pc:sldMk cId="1136879520" sldId="257"/>
            <ac:picMk id="13" creationId="{8152F9A4-CDAD-CE04-0032-06C8404E5A34}"/>
          </ac:picMkLst>
        </pc:picChg>
        <pc:picChg chg="add del mod">
          <ac:chgData name="Dominik Aumann" userId="013c187a20e8f01a" providerId="LiveId" clId="{C80A0E3D-4327-47AD-AF4E-C5A9CC23AC99}" dt="2024-02-26T00:16:38.353" v="551" actId="21"/>
          <ac:picMkLst>
            <pc:docMk/>
            <pc:sldMk cId="1136879520" sldId="257"/>
            <ac:picMk id="15" creationId="{8054D3D4-48AF-A4D2-DEEB-4E04059A4644}"/>
          </ac:picMkLst>
        </pc:picChg>
        <pc:picChg chg="add del mod">
          <ac:chgData name="Dominik Aumann" userId="013c187a20e8f01a" providerId="LiveId" clId="{C80A0E3D-4327-47AD-AF4E-C5A9CC23AC99}" dt="2024-02-25T23:54:38.240" v="95" actId="21"/>
          <ac:picMkLst>
            <pc:docMk/>
            <pc:sldMk cId="1136879520" sldId="257"/>
            <ac:picMk id="17" creationId="{AC574D1C-896E-D726-EE61-AC96A23637F3}"/>
          </ac:picMkLst>
        </pc:picChg>
        <pc:picChg chg="add del mod">
          <ac:chgData name="Dominik Aumann" userId="013c187a20e8f01a" providerId="LiveId" clId="{C80A0E3D-4327-47AD-AF4E-C5A9CC23AC99}" dt="2024-02-25T23:54:04.045" v="81" actId="21"/>
          <ac:picMkLst>
            <pc:docMk/>
            <pc:sldMk cId="1136879520" sldId="257"/>
            <ac:picMk id="19" creationId="{09B9F772-D821-675B-B346-DDCA60528223}"/>
          </ac:picMkLst>
        </pc:picChg>
        <pc:picChg chg="add del mod">
          <ac:chgData name="Dominik Aumann" userId="013c187a20e8f01a" providerId="LiveId" clId="{C80A0E3D-4327-47AD-AF4E-C5A9CC23AC99}" dt="2024-02-26T00:16:11.063" v="543" actId="21"/>
          <ac:picMkLst>
            <pc:docMk/>
            <pc:sldMk cId="1136879520" sldId="257"/>
            <ac:picMk id="93" creationId="{310A52E4-CE42-2C3B-204D-DCD246EA8656}"/>
          </ac:picMkLst>
        </pc:picChg>
        <pc:picChg chg="add del mod">
          <ac:chgData name="Dominik Aumann" userId="013c187a20e8f01a" providerId="LiveId" clId="{C80A0E3D-4327-47AD-AF4E-C5A9CC23AC99}" dt="2024-02-26T00:16:27.403" v="547" actId="21"/>
          <ac:picMkLst>
            <pc:docMk/>
            <pc:sldMk cId="1136879520" sldId="257"/>
            <ac:picMk id="94" creationId="{627E6BFD-4079-E1EE-AEA5-76B3DC4B70BA}"/>
          </ac:picMkLst>
        </pc:picChg>
      </pc:sldChg>
      <pc:sldChg chg="addSp delSp modSp add mod">
        <pc:chgData name="Dominik Aumann" userId="013c187a20e8f01a" providerId="LiveId" clId="{C80A0E3D-4327-47AD-AF4E-C5A9CC23AC99}" dt="2024-02-26T00:42:11.217" v="1207" actId="1037"/>
        <pc:sldMkLst>
          <pc:docMk/>
          <pc:sldMk cId="2120268309" sldId="258"/>
        </pc:sldMkLst>
        <pc:spChg chg="del">
          <ac:chgData name="Dominik Aumann" userId="013c187a20e8f01a" providerId="LiveId" clId="{C80A0E3D-4327-47AD-AF4E-C5A9CC23AC99}" dt="2024-02-25T23:56:46.908" v="147" actId="478"/>
          <ac:spMkLst>
            <pc:docMk/>
            <pc:sldMk cId="2120268309" sldId="258"/>
            <ac:spMk id="12" creationId="{4866B665-F755-F02C-BC91-6130894E7CAF}"/>
          </ac:spMkLst>
        </pc:spChg>
        <pc:spChg chg="del">
          <ac:chgData name="Dominik Aumann" userId="013c187a20e8f01a" providerId="LiveId" clId="{C80A0E3D-4327-47AD-AF4E-C5A9CC23AC99}" dt="2024-02-25T23:56:03.845" v="121" actId="478"/>
          <ac:spMkLst>
            <pc:docMk/>
            <pc:sldMk cId="2120268309" sldId="258"/>
            <ac:spMk id="15" creationId="{D9F1FE76-6A6A-F6E5-CDE4-AB021498D2D0}"/>
          </ac:spMkLst>
        </pc:spChg>
        <pc:spChg chg="del">
          <ac:chgData name="Dominik Aumann" userId="013c187a20e8f01a" providerId="LiveId" clId="{C80A0E3D-4327-47AD-AF4E-C5A9CC23AC99}" dt="2024-02-25T23:56:04.907" v="122" actId="478"/>
          <ac:spMkLst>
            <pc:docMk/>
            <pc:sldMk cId="2120268309" sldId="258"/>
            <ac:spMk id="16" creationId="{AFA9A6A1-BB5B-1ED0-2C5C-DB7FD14EA8E6}"/>
          </ac:spMkLst>
        </pc:spChg>
        <pc:spChg chg="del">
          <ac:chgData name="Dominik Aumann" userId="013c187a20e8f01a" providerId="LiveId" clId="{C80A0E3D-4327-47AD-AF4E-C5A9CC23AC99}" dt="2024-02-25T23:56:37.931" v="146" actId="478"/>
          <ac:spMkLst>
            <pc:docMk/>
            <pc:sldMk cId="2120268309" sldId="258"/>
            <ac:spMk id="17" creationId="{8B1EABCF-979B-C6D9-9A2C-BA452E4CD28D}"/>
          </ac:spMkLst>
        </pc:spChg>
        <pc:spChg chg="del">
          <ac:chgData name="Dominik Aumann" userId="013c187a20e8f01a" providerId="LiveId" clId="{C80A0E3D-4327-47AD-AF4E-C5A9CC23AC99}" dt="2024-02-25T23:57:20.962" v="155" actId="478"/>
          <ac:spMkLst>
            <pc:docMk/>
            <pc:sldMk cId="2120268309" sldId="258"/>
            <ac:spMk id="18" creationId="{B4C54165-1311-A267-81FE-69AB1FC5C069}"/>
          </ac:spMkLst>
        </pc:spChg>
        <pc:spChg chg="del">
          <ac:chgData name="Dominik Aumann" userId="013c187a20e8f01a" providerId="LiveId" clId="{C80A0E3D-4327-47AD-AF4E-C5A9CC23AC99}" dt="2024-02-25T23:56:29.293" v="141" actId="478"/>
          <ac:spMkLst>
            <pc:docMk/>
            <pc:sldMk cId="2120268309" sldId="258"/>
            <ac:spMk id="20" creationId="{49B4CC5E-4B6F-3296-C3D4-6F444CD4F7B1}"/>
          </ac:spMkLst>
        </pc:spChg>
        <pc:spChg chg="del">
          <ac:chgData name="Dominik Aumann" userId="013c187a20e8f01a" providerId="LiveId" clId="{C80A0E3D-4327-47AD-AF4E-C5A9CC23AC99}" dt="2024-02-25T23:56:03.845" v="121" actId="478"/>
          <ac:spMkLst>
            <pc:docMk/>
            <pc:sldMk cId="2120268309" sldId="258"/>
            <ac:spMk id="21" creationId="{7CB7A0C2-A636-4A0A-5853-278F023D29C6}"/>
          </ac:spMkLst>
        </pc:spChg>
        <pc:spChg chg="del">
          <ac:chgData name="Dominik Aumann" userId="013c187a20e8f01a" providerId="LiveId" clId="{C80A0E3D-4327-47AD-AF4E-C5A9CC23AC99}" dt="2024-02-25T23:56:05.720" v="123" actId="478"/>
          <ac:spMkLst>
            <pc:docMk/>
            <pc:sldMk cId="2120268309" sldId="258"/>
            <ac:spMk id="22" creationId="{BEEEC5A8-290F-E190-1938-425B60324480}"/>
          </ac:spMkLst>
        </pc:spChg>
        <pc:spChg chg="del">
          <ac:chgData name="Dominik Aumann" userId="013c187a20e8f01a" providerId="LiveId" clId="{C80A0E3D-4327-47AD-AF4E-C5A9CC23AC99}" dt="2024-02-25T23:56:34.057" v="143" actId="478"/>
          <ac:spMkLst>
            <pc:docMk/>
            <pc:sldMk cId="2120268309" sldId="258"/>
            <ac:spMk id="23" creationId="{FFA39EEB-243C-1E60-2259-2555691D8B0F}"/>
          </ac:spMkLst>
        </pc:spChg>
        <pc:spChg chg="del">
          <ac:chgData name="Dominik Aumann" userId="013c187a20e8f01a" providerId="LiveId" clId="{C80A0E3D-4327-47AD-AF4E-C5A9CC23AC99}" dt="2024-02-25T23:56:27.949" v="140" actId="478"/>
          <ac:spMkLst>
            <pc:docMk/>
            <pc:sldMk cId="2120268309" sldId="258"/>
            <ac:spMk id="27" creationId="{45ED0735-8179-61E4-0999-38C5D4071F40}"/>
          </ac:spMkLst>
        </pc:spChg>
        <pc:spChg chg="del">
          <ac:chgData name="Dominik Aumann" userId="013c187a20e8f01a" providerId="LiveId" clId="{C80A0E3D-4327-47AD-AF4E-C5A9CC23AC99}" dt="2024-02-25T23:56:03.845" v="121" actId="478"/>
          <ac:spMkLst>
            <pc:docMk/>
            <pc:sldMk cId="2120268309" sldId="258"/>
            <ac:spMk id="28" creationId="{7D7F2BD9-A120-0A91-F0E7-CC08A67E03E7}"/>
          </ac:spMkLst>
        </pc:spChg>
        <pc:spChg chg="del">
          <ac:chgData name="Dominik Aumann" userId="013c187a20e8f01a" providerId="LiveId" clId="{C80A0E3D-4327-47AD-AF4E-C5A9CC23AC99}" dt="2024-02-25T23:56:06.469" v="124" actId="478"/>
          <ac:spMkLst>
            <pc:docMk/>
            <pc:sldMk cId="2120268309" sldId="258"/>
            <ac:spMk id="29" creationId="{689D3E26-F3EE-8D96-F11D-4CBE724F6514}"/>
          </ac:spMkLst>
        </pc:spChg>
        <pc:spChg chg="del">
          <ac:chgData name="Dominik Aumann" userId="013c187a20e8f01a" providerId="LiveId" clId="{C80A0E3D-4327-47AD-AF4E-C5A9CC23AC99}" dt="2024-02-25T23:56:33.463" v="142" actId="478"/>
          <ac:spMkLst>
            <pc:docMk/>
            <pc:sldMk cId="2120268309" sldId="258"/>
            <ac:spMk id="30" creationId="{7BD1B26E-FEDE-8689-D183-B8AEC8467490}"/>
          </ac:spMkLst>
        </pc:spChg>
        <pc:spChg chg="del">
          <ac:chgData name="Dominik Aumann" userId="013c187a20e8f01a" providerId="LiveId" clId="{C80A0E3D-4327-47AD-AF4E-C5A9CC23AC99}" dt="2024-02-25T23:57:19.149" v="153" actId="478"/>
          <ac:spMkLst>
            <pc:docMk/>
            <pc:sldMk cId="2120268309" sldId="258"/>
            <ac:spMk id="31" creationId="{C1E53CFC-0559-F002-4770-35A1D8C35E85}"/>
          </ac:spMkLst>
        </pc:spChg>
        <pc:spChg chg="del">
          <ac:chgData name="Dominik Aumann" userId="013c187a20e8f01a" providerId="LiveId" clId="{C80A0E3D-4327-47AD-AF4E-C5A9CC23AC99}" dt="2024-02-25T23:57:19.930" v="154" actId="478"/>
          <ac:spMkLst>
            <pc:docMk/>
            <pc:sldMk cId="2120268309" sldId="258"/>
            <ac:spMk id="34" creationId="{55C499BA-69F3-A192-B30F-93FDCDCCFC53}"/>
          </ac:spMkLst>
        </pc:spChg>
        <pc:spChg chg="del">
          <ac:chgData name="Dominik Aumann" userId="013c187a20e8f01a" providerId="LiveId" clId="{C80A0E3D-4327-47AD-AF4E-C5A9CC23AC99}" dt="2024-02-25T23:56:26.356" v="139" actId="478"/>
          <ac:spMkLst>
            <pc:docMk/>
            <pc:sldMk cId="2120268309" sldId="258"/>
            <ac:spMk id="35" creationId="{D1125225-4DB6-3F3E-7562-11383F06C3FD}"/>
          </ac:spMkLst>
        </pc:spChg>
        <pc:spChg chg="del">
          <ac:chgData name="Dominik Aumann" userId="013c187a20e8f01a" providerId="LiveId" clId="{C80A0E3D-4327-47AD-AF4E-C5A9CC23AC99}" dt="2024-02-25T23:56:03.845" v="121" actId="478"/>
          <ac:spMkLst>
            <pc:docMk/>
            <pc:sldMk cId="2120268309" sldId="258"/>
            <ac:spMk id="36" creationId="{4B2C51A3-9956-293F-5ED8-EE628A534BD6}"/>
          </ac:spMkLst>
        </pc:spChg>
        <pc:spChg chg="del">
          <ac:chgData name="Dominik Aumann" userId="013c187a20e8f01a" providerId="LiveId" clId="{C80A0E3D-4327-47AD-AF4E-C5A9CC23AC99}" dt="2024-02-25T23:56:07.188" v="125" actId="478"/>
          <ac:spMkLst>
            <pc:docMk/>
            <pc:sldMk cId="2120268309" sldId="258"/>
            <ac:spMk id="37" creationId="{A8F20648-191C-1A31-2F19-90B9DB1EC91F}"/>
          </ac:spMkLst>
        </pc:spChg>
        <pc:spChg chg="del">
          <ac:chgData name="Dominik Aumann" userId="013c187a20e8f01a" providerId="LiveId" clId="{C80A0E3D-4327-47AD-AF4E-C5A9CC23AC99}" dt="2024-02-25T23:56:24.887" v="138" actId="478"/>
          <ac:spMkLst>
            <pc:docMk/>
            <pc:sldMk cId="2120268309" sldId="258"/>
            <ac:spMk id="38" creationId="{2C7EC200-FACD-01E5-E32C-71120EFA4428}"/>
          </ac:spMkLst>
        </pc:spChg>
        <pc:spChg chg="del">
          <ac:chgData name="Dominik Aumann" userId="013c187a20e8f01a" providerId="LiveId" clId="{C80A0E3D-4327-47AD-AF4E-C5A9CC23AC99}" dt="2024-02-25T23:57:18.087" v="152" actId="478"/>
          <ac:spMkLst>
            <pc:docMk/>
            <pc:sldMk cId="2120268309" sldId="258"/>
            <ac:spMk id="39" creationId="{6AC3123C-644B-B018-A49B-A0D68366F599}"/>
          </ac:spMkLst>
        </pc:spChg>
        <pc:spChg chg="del mod">
          <ac:chgData name="Dominik Aumann" userId="013c187a20e8f01a" providerId="LiveId" clId="{C80A0E3D-4327-47AD-AF4E-C5A9CC23AC99}" dt="2024-02-25T23:56:23.309" v="137" actId="478"/>
          <ac:spMkLst>
            <pc:docMk/>
            <pc:sldMk cId="2120268309" sldId="258"/>
            <ac:spMk id="46" creationId="{1E65457D-8B11-2A7F-84B5-5C5A628C7D0A}"/>
          </ac:spMkLst>
        </pc:spChg>
        <pc:spChg chg="del">
          <ac:chgData name="Dominik Aumann" userId="013c187a20e8f01a" providerId="LiveId" clId="{C80A0E3D-4327-47AD-AF4E-C5A9CC23AC99}" dt="2024-02-25T23:56:03.845" v="121" actId="478"/>
          <ac:spMkLst>
            <pc:docMk/>
            <pc:sldMk cId="2120268309" sldId="258"/>
            <ac:spMk id="47" creationId="{1AB7C2E4-7818-234F-D44B-2ECCFF33C66E}"/>
          </ac:spMkLst>
        </pc:spChg>
        <pc:spChg chg="del">
          <ac:chgData name="Dominik Aumann" userId="013c187a20e8f01a" providerId="LiveId" clId="{C80A0E3D-4327-47AD-AF4E-C5A9CC23AC99}" dt="2024-02-25T23:56:09.906" v="127" actId="478"/>
          <ac:spMkLst>
            <pc:docMk/>
            <pc:sldMk cId="2120268309" sldId="258"/>
            <ac:spMk id="48" creationId="{F474B77D-CC42-3391-B293-8BF651B767DC}"/>
          </ac:spMkLst>
        </pc:spChg>
        <pc:spChg chg="del mod">
          <ac:chgData name="Dominik Aumann" userId="013c187a20e8f01a" providerId="LiveId" clId="{C80A0E3D-4327-47AD-AF4E-C5A9CC23AC99}" dt="2024-02-25T23:57:23.164" v="156" actId="478"/>
          <ac:spMkLst>
            <pc:docMk/>
            <pc:sldMk cId="2120268309" sldId="258"/>
            <ac:spMk id="49" creationId="{AE990EF1-CA5F-BF8E-07CE-B9E96FB76DA6}"/>
          </ac:spMkLst>
        </pc:spChg>
        <pc:spChg chg="del">
          <ac:chgData name="Dominik Aumann" userId="013c187a20e8f01a" providerId="LiveId" clId="{C80A0E3D-4327-47AD-AF4E-C5A9CC23AC99}" dt="2024-02-25T23:57:17.134" v="151" actId="478"/>
          <ac:spMkLst>
            <pc:docMk/>
            <pc:sldMk cId="2120268309" sldId="258"/>
            <ac:spMk id="50" creationId="{D531124B-2CBE-88B6-1BB2-BD27F9148C29}"/>
          </ac:spMkLst>
        </pc:spChg>
        <pc:spChg chg="del">
          <ac:chgData name="Dominik Aumann" userId="013c187a20e8f01a" providerId="LiveId" clId="{C80A0E3D-4327-47AD-AF4E-C5A9CC23AC99}" dt="2024-02-25T23:55:59.315" v="119" actId="478"/>
          <ac:spMkLst>
            <pc:docMk/>
            <pc:sldMk cId="2120268309" sldId="258"/>
            <ac:spMk id="53" creationId="{6CBD00BD-84C8-29D6-AB51-747BF516952B}"/>
          </ac:spMkLst>
        </pc:spChg>
        <pc:spChg chg="del mod">
          <ac:chgData name="Dominik Aumann" userId="013c187a20e8f01a" providerId="LiveId" clId="{C80A0E3D-4327-47AD-AF4E-C5A9CC23AC99}" dt="2024-02-25T23:56:15.218" v="132" actId="478"/>
          <ac:spMkLst>
            <pc:docMk/>
            <pc:sldMk cId="2120268309" sldId="258"/>
            <ac:spMk id="54" creationId="{080E45A7-20C2-BC4A-A77C-C6C99048AD8B}"/>
          </ac:spMkLst>
        </pc:spChg>
        <pc:spChg chg="del">
          <ac:chgData name="Dominik Aumann" userId="013c187a20e8f01a" providerId="LiveId" clId="{C80A0E3D-4327-47AD-AF4E-C5A9CC23AC99}" dt="2024-02-25T23:56:09.125" v="126" actId="478"/>
          <ac:spMkLst>
            <pc:docMk/>
            <pc:sldMk cId="2120268309" sldId="258"/>
            <ac:spMk id="55" creationId="{B6FCF6A9-FD99-E30A-F7E2-608ADC00A40E}"/>
          </ac:spMkLst>
        </pc:spChg>
        <pc:spChg chg="del">
          <ac:chgData name="Dominik Aumann" userId="013c187a20e8f01a" providerId="LiveId" clId="{C80A0E3D-4327-47AD-AF4E-C5A9CC23AC99}" dt="2024-02-25T23:56:21.279" v="135" actId="478"/>
          <ac:spMkLst>
            <pc:docMk/>
            <pc:sldMk cId="2120268309" sldId="258"/>
            <ac:spMk id="56" creationId="{7F720F71-92B8-28FC-045A-605AF439D7E3}"/>
          </ac:spMkLst>
        </pc:spChg>
        <pc:spChg chg="del">
          <ac:chgData name="Dominik Aumann" userId="013c187a20e8f01a" providerId="LiveId" clId="{C80A0E3D-4327-47AD-AF4E-C5A9CC23AC99}" dt="2024-02-25T23:57:31.225" v="159" actId="478"/>
          <ac:spMkLst>
            <pc:docMk/>
            <pc:sldMk cId="2120268309" sldId="258"/>
            <ac:spMk id="57" creationId="{354BAB6D-CD5D-13BE-17D3-7F7B2C131CAF}"/>
          </ac:spMkLst>
        </pc:spChg>
        <pc:spChg chg="del">
          <ac:chgData name="Dominik Aumann" userId="013c187a20e8f01a" providerId="LiveId" clId="{C80A0E3D-4327-47AD-AF4E-C5A9CC23AC99}" dt="2024-02-25T23:57:15.510" v="150" actId="478"/>
          <ac:spMkLst>
            <pc:docMk/>
            <pc:sldMk cId="2120268309" sldId="258"/>
            <ac:spMk id="60" creationId="{7017F7FA-D083-78F4-CE1B-2E896854B1A0}"/>
          </ac:spMkLst>
        </pc:spChg>
        <pc:spChg chg="del">
          <ac:chgData name="Dominik Aumann" userId="013c187a20e8f01a" providerId="LiveId" clId="{C80A0E3D-4327-47AD-AF4E-C5A9CC23AC99}" dt="2024-02-25T23:56:12.218" v="129" actId="478"/>
          <ac:spMkLst>
            <pc:docMk/>
            <pc:sldMk cId="2120268309" sldId="258"/>
            <ac:spMk id="61" creationId="{41014326-0FFF-F4A1-EDCC-7E097D3EB9A1}"/>
          </ac:spMkLst>
        </pc:spChg>
        <pc:spChg chg="del">
          <ac:chgData name="Dominik Aumann" userId="013c187a20e8f01a" providerId="LiveId" clId="{C80A0E3D-4327-47AD-AF4E-C5A9CC23AC99}" dt="2024-02-25T23:56:11" v="128" actId="478"/>
          <ac:spMkLst>
            <pc:docMk/>
            <pc:sldMk cId="2120268309" sldId="258"/>
            <ac:spMk id="62" creationId="{390DA488-3B0A-F784-0B89-6092DDC641CA}"/>
          </ac:spMkLst>
        </pc:spChg>
        <pc:spChg chg="del">
          <ac:chgData name="Dominik Aumann" userId="013c187a20e8f01a" providerId="LiveId" clId="{C80A0E3D-4327-47AD-AF4E-C5A9CC23AC99}" dt="2024-02-25T23:56:19.904" v="134" actId="478"/>
          <ac:spMkLst>
            <pc:docMk/>
            <pc:sldMk cId="2120268309" sldId="258"/>
            <ac:spMk id="63" creationId="{9D817B46-D676-B44E-1EF9-F5D033273448}"/>
          </ac:spMkLst>
        </pc:spChg>
        <pc:spChg chg="del">
          <ac:chgData name="Dominik Aumann" userId="013c187a20e8f01a" providerId="LiveId" clId="{C80A0E3D-4327-47AD-AF4E-C5A9CC23AC99}" dt="2024-02-25T23:57:31.225" v="159" actId="478"/>
          <ac:spMkLst>
            <pc:docMk/>
            <pc:sldMk cId="2120268309" sldId="258"/>
            <ac:spMk id="64" creationId="{ED44A2DD-2324-D414-A0B3-0FCE42039945}"/>
          </ac:spMkLst>
        </pc:spChg>
        <pc:spChg chg="del">
          <ac:chgData name="Dominik Aumann" userId="013c187a20e8f01a" providerId="LiveId" clId="{C80A0E3D-4327-47AD-AF4E-C5A9CC23AC99}" dt="2024-02-25T23:57:14.869" v="149" actId="478"/>
          <ac:spMkLst>
            <pc:docMk/>
            <pc:sldMk cId="2120268309" sldId="258"/>
            <ac:spMk id="69" creationId="{A417B34C-451D-4812-E94C-4BA9E19C8D99}"/>
          </ac:spMkLst>
        </pc:spChg>
        <pc:spChg chg="del">
          <ac:chgData name="Dominik Aumann" userId="013c187a20e8f01a" providerId="LiveId" clId="{C80A0E3D-4327-47AD-AF4E-C5A9CC23AC99}" dt="2024-02-25T23:57:10.886" v="148" actId="478"/>
          <ac:spMkLst>
            <pc:docMk/>
            <pc:sldMk cId="2120268309" sldId="258"/>
            <ac:spMk id="70" creationId="{BF76D373-B342-7CF3-7EF6-5BB6673C68FC}"/>
          </ac:spMkLst>
        </pc:spChg>
        <pc:spChg chg="del">
          <ac:chgData name="Dominik Aumann" userId="013c187a20e8f01a" providerId="LiveId" clId="{C80A0E3D-4327-47AD-AF4E-C5A9CC23AC99}" dt="2024-02-25T23:57:26.601" v="158" actId="478"/>
          <ac:spMkLst>
            <pc:docMk/>
            <pc:sldMk cId="2120268309" sldId="258"/>
            <ac:spMk id="71" creationId="{566AA3CC-EDCE-845C-A437-1533FAA82692}"/>
          </ac:spMkLst>
        </pc:spChg>
        <pc:spChg chg="del">
          <ac:chgData name="Dominik Aumann" userId="013c187a20e8f01a" providerId="LiveId" clId="{C80A0E3D-4327-47AD-AF4E-C5A9CC23AC99}" dt="2024-02-25T23:57:25.070" v="157" actId="478"/>
          <ac:spMkLst>
            <pc:docMk/>
            <pc:sldMk cId="2120268309" sldId="258"/>
            <ac:spMk id="72" creationId="{B7779436-C8A3-8B1F-DA8A-0F8A1439DE46}"/>
          </ac:spMkLst>
        </pc:spChg>
        <pc:spChg chg="del">
          <ac:chgData name="Dominik Aumann" userId="013c187a20e8f01a" providerId="LiveId" clId="{C80A0E3D-4327-47AD-AF4E-C5A9CC23AC99}" dt="2024-02-25T23:57:31.225" v="159" actId="478"/>
          <ac:spMkLst>
            <pc:docMk/>
            <pc:sldMk cId="2120268309" sldId="258"/>
            <ac:spMk id="73" creationId="{B2B4B850-BA2D-2848-8E3F-0FD60B9ADB6C}"/>
          </ac:spMkLst>
        </pc:spChg>
        <pc:spChg chg="mod">
          <ac:chgData name="Dominik Aumann" userId="013c187a20e8f01a" providerId="LiveId" clId="{C80A0E3D-4327-47AD-AF4E-C5A9CC23AC99}" dt="2024-02-26T00:20:54.519" v="603" actId="1076"/>
          <ac:spMkLst>
            <pc:docMk/>
            <pc:sldMk cId="2120268309" sldId="258"/>
            <ac:spMk id="83" creationId="{2833FD60-11A4-8CB0-C795-360AE17CAB2B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98" creationId="{F68F0C4D-D507-A071-2AD9-A1244ADE007F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99" creationId="{F2462140-6A76-7D8C-C756-CCD4E74EA0A1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0" creationId="{CA98E284-B8DB-BE43-1B89-FFDDF30C90A8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1" creationId="{8A6825E9-1BD2-44B4-ADB9-056E17B5958A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2" creationId="{12D91684-FE45-25ED-9342-CE5CA28A3464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3" creationId="{D4DA3CB6-6E9D-5D1D-1B74-911CB472BF92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4" creationId="{141EA4CD-09BC-FCA8-2D16-E146079229EC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5" creationId="{048B679C-E57D-68B9-F03E-D39F115C3CDE}"/>
          </ac:spMkLst>
        </pc:spChg>
        <pc:spChg chg="add del mod">
          <ac:chgData name="Dominik Aumann" userId="013c187a20e8f01a" providerId="LiveId" clId="{C80A0E3D-4327-47AD-AF4E-C5A9CC23AC99}" dt="2024-02-26T00:12:51.328" v="408" actId="478"/>
          <ac:spMkLst>
            <pc:docMk/>
            <pc:sldMk cId="2120268309" sldId="258"/>
            <ac:spMk id="106" creationId="{C681AF02-243D-7BF9-2DF6-B215EA84CB05}"/>
          </ac:spMkLst>
        </pc:spChg>
        <pc:spChg chg="add del mod">
          <ac:chgData name="Dominik Aumann" userId="013c187a20e8f01a" providerId="LiveId" clId="{C80A0E3D-4327-47AD-AF4E-C5A9CC23AC99}" dt="2024-02-26T00:12:51.328" v="408" actId="478"/>
          <ac:spMkLst>
            <pc:docMk/>
            <pc:sldMk cId="2120268309" sldId="258"/>
            <ac:spMk id="107" creationId="{781DCF30-C7CF-11F6-7099-34B20A123C6F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8" creationId="{1B14E0D2-A0F0-52B3-8F2A-CDDF3CFBCB38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09" creationId="{BD7290CB-FE5A-7B30-6053-D9BC918E26CC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10" creationId="{EFA3F686-F9F3-1188-97F4-E897DA72FB3A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11" creationId="{4709B30B-9441-936E-1642-1994A18D9D4A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12" creationId="{3DEC5038-5F67-0F60-383F-D2B75D66BEC7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13" creationId="{DF3E1DF4-750F-0F8B-905E-D42F5DE97B84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14" creationId="{6024AE4F-93ED-C50D-C6F9-BA4C5FD89C0C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15" creationId="{FE761E38-5556-8166-EA07-0D835F458BCE}"/>
          </ac:spMkLst>
        </pc:spChg>
        <pc:spChg chg="add mod">
          <ac:chgData name="Dominik Aumann" userId="013c187a20e8f01a" providerId="LiveId" clId="{C80A0E3D-4327-47AD-AF4E-C5A9CC23AC99}" dt="2024-02-26T00:38:44.875" v="942" actId="1036"/>
          <ac:spMkLst>
            <pc:docMk/>
            <pc:sldMk cId="2120268309" sldId="258"/>
            <ac:spMk id="116" creationId="{7F8A8251-A194-7D59-889D-9FEA674DD03A}"/>
          </ac:spMkLst>
        </pc:spChg>
        <pc:spChg chg="add mod">
          <ac:chgData name="Dominik Aumann" userId="013c187a20e8f01a" providerId="LiveId" clId="{C80A0E3D-4327-47AD-AF4E-C5A9CC23AC99}" dt="2024-02-26T00:38:52.202" v="948" actId="1036"/>
          <ac:spMkLst>
            <pc:docMk/>
            <pc:sldMk cId="2120268309" sldId="258"/>
            <ac:spMk id="117" creationId="{592734A0-DB43-3A49-EF67-633E3A96F7A8}"/>
          </ac:spMkLst>
        </pc:spChg>
        <pc:spChg chg="add mod">
          <ac:chgData name="Dominik Aumann" userId="013c187a20e8f01a" providerId="LiveId" clId="{C80A0E3D-4327-47AD-AF4E-C5A9CC23AC99}" dt="2024-02-26T00:38:34.284" v="932" actId="1076"/>
          <ac:spMkLst>
            <pc:docMk/>
            <pc:sldMk cId="2120268309" sldId="258"/>
            <ac:spMk id="118" creationId="{EA83F00A-DB94-55B9-CFA6-55DF35CB5FD5}"/>
          </ac:spMkLst>
        </pc:spChg>
        <pc:spChg chg="add mod">
          <ac:chgData name="Dominik Aumann" userId="013c187a20e8f01a" providerId="LiveId" clId="{C80A0E3D-4327-47AD-AF4E-C5A9CC23AC99}" dt="2024-02-26T00:38:55.435" v="949" actId="1035"/>
          <ac:spMkLst>
            <pc:docMk/>
            <pc:sldMk cId="2120268309" sldId="258"/>
            <ac:spMk id="119" creationId="{E028E562-FFFE-B41F-1FB7-F39CCFC10B98}"/>
          </ac:spMkLst>
        </pc:spChg>
        <pc:spChg chg="add mod">
          <ac:chgData name="Dominik Aumann" userId="013c187a20e8f01a" providerId="LiveId" clId="{C80A0E3D-4327-47AD-AF4E-C5A9CC23AC99}" dt="2024-02-26T00:37:28.503" v="917" actId="1076"/>
          <ac:spMkLst>
            <pc:docMk/>
            <pc:sldMk cId="2120268309" sldId="258"/>
            <ac:spMk id="120" creationId="{CFAF2CA7-C7C8-59F7-724F-F3511BE5A864}"/>
          </ac:spMkLst>
        </pc:spChg>
        <pc:spChg chg="add mod">
          <ac:chgData name="Dominik Aumann" userId="013c187a20e8f01a" providerId="LiveId" clId="{C80A0E3D-4327-47AD-AF4E-C5A9CC23AC99}" dt="2024-02-26T00:39:03.964" v="957" actId="1035"/>
          <ac:spMkLst>
            <pc:docMk/>
            <pc:sldMk cId="2120268309" sldId="258"/>
            <ac:spMk id="121" creationId="{FC124919-16FA-7524-26DF-52FBCF37D0C6}"/>
          </ac:spMkLst>
        </pc:spChg>
        <pc:spChg chg="add mod">
          <ac:chgData name="Dominik Aumann" userId="013c187a20e8f01a" providerId="LiveId" clId="{C80A0E3D-4327-47AD-AF4E-C5A9CC23AC99}" dt="2024-02-26T00:39:05.995" v="958" actId="1035"/>
          <ac:spMkLst>
            <pc:docMk/>
            <pc:sldMk cId="2120268309" sldId="258"/>
            <ac:spMk id="122" creationId="{A7F3C120-90F3-F41A-A0FD-A17FA5CB7E32}"/>
          </ac:spMkLst>
        </pc:spChg>
        <pc:spChg chg="add mod">
          <ac:chgData name="Dominik Aumann" userId="013c187a20e8f01a" providerId="LiveId" clId="{C80A0E3D-4327-47AD-AF4E-C5A9CC23AC99}" dt="2024-02-26T00:39:10.900" v="962" actId="1035"/>
          <ac:spMkLst>
            <pc:docMk/>
            <pc:sldMk cId="2120268309" sldId="258"/>
            <ac:spMk id="123" creationId="{F46CC9BB-9123-93A3-4662-9D0175672AEE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42" creationId="{AFA55AFB-1B67-B505-E74E-81E0F440E351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43" creationId="{75AB651C-7DD5-79D7-4189-1871359F6750}"/>
          </ac:spMkLst>
        </pc:spChg>
        <pc:spChg chg="add mod">
          <ac:chgData name="Dominik Aumann" userId="013c187a20e8f01a" providerId="LiveId" clId="{C80A0E3D-4327-47AD-AF4E-C5A9CC23AC99}" dt="2024-02-26T00:27:04.666" v="676"/>
          <ac:spMkLst>
            <pc:docMk/>
            <pc:sldMk cId="2120268309" sldId="258"/>
            <ac:spMk id="144" creationId="{4D01205E-8EB4-B8FA-B61D-B257B9956D34}"/>
          </ac:spMkLst>
        </pc:spChg>
        <pc:spChg chg="add mod">
          <ac:chgData name="Dominik Aumann" userId="013c187a20e8f01a" providerId="LiveId" clId="{C80A0E3D-4327-47AD-AF4E-C5A9CC23AC99}" dt="2024-02-26T00:27:04.666" v="676"/>
          <ac:spMkLst>
            <pc:docMk/>
            <pc:sldMk cId="2120268309" sldId="258"/>
            <ac:spMk id="145" creationId="{BC9AB7EB-D0F5-3EE9-05D3-95D97CFECACB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46" creationId="{51B4CB83-911A-5E21-6301-597D213ACA80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47" creationId="{4488FE14-3D56-435F-AD5E-3759E112CFED}"/>
          </ac:spMkLst>
        </pc:spChg>
        <pc:spChg chg="add del mod">
          <ac:chgData name="Dominik Aumann" userId="013c187a20e8f01a" providerId="LiveId" clId="{C80A0E3D-4327-47AD-AF4E-C5A9CC23AC99}" dt="2024-02-26T00:27:53.233" v="694" actId="478"/>
          <ac:spMkLst>
            <pc:docMk/>
            <pc:sldMk cId="2120268309" sldId="258"/>
            <ac:spMk id="148" creationId="{821D0537-5AF4-D570-ADA5-2511C0905043}"/>
          </ac:spMkLst>
        </pc:spChg>
        <pc:spChg chg="add del mod">
          <ac:chgData name="Dominik Aumann" userId="013c187a20e8f01a" providerId="LiveId" clId="{C80A0E3D-4327-47AD-AF4E-C5A9CC23AC99}" dt="2024-02-26T00:27:57.966" v="695" actId="478"/>
          <ac:spMkLst>
            <pc:docMk/>
            <pc:sldMk cId="2120268309" sldId="258"/>
            <ac:spMk id="149" creationId="{F80367B0-AB13-51E8-592A-BC2F0FF7E9B4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0" creationId="{4823593B-863C-5557-F774-BA26275F239C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1" creationId="{3B2ECA27-1335-23F4-F2D1-C0030AEBB7A2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2" creationId="{2D9FF839-547F-0122-C464-2CC47FE089BD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3" creationId="{AFF77C22-C118-17DB-5E9F-0415B85AA6F5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4" creationId="{41F6D349-F8D6-4785-33E5-BC9082CF8D25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5" creationId="{79B3950F-44C4-9331-896A-F65EE407D9D0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6" creationId="{F52415A1-13F5-F0C4-C62F-381D3CCE0619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7" creationId="{13DB192E-AEAB-79B8-AD07-8E1149312C9B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8" creationId="{0CE230ED-4F66-00EA-CA33-8BBC24393AC8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59" creationId="{6502D331-8975-8529-B7F9-AA8BFD2F94E4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60" creationId="{29994C4E-268D-007B-C221-51BCD34AD1D9}"/>
          </ac:spMkLst>
        </pc:spChg>
        <pc:spChg chg="add mod">
          <ac:chgData name="Dominik Aumann" userId="013c187a20e8f01a" providerId="LiveId" clId="{C80A0E3D-4327-47AD-AF4E-C5A9CC23AC99}" dt="2024-02-26T00:36:45.466" v="901" actId="1036"/>
          <ac:spMkLst>
            <pc:docMk/>
            <pc:sldMk cId="2120268309" sldId="258"/>
            <ac:spMk id="161" creationId="{52BF61CC-D6D4-51DF-0D16-B33E8BD14DE0}"/>
          </ac:spMkLst>
        </pc:spChg>
        <pc:picChg chg="add del mod">
          <ac:chgData name="Dominik Aumann" userId="013c187a20e8f01a" providerId="LiveId" clId="{C80A0E3D-4327-47AD-AF4E-C5A9CC23AC99}" dt="2024-02-26T00:01:21.699" v="175" actId="478"/>
          <ac:picMkLst>
            <pc:docMk/>
            <pc:sldMk cId="2120268309" sldId="258"/>
            <ac:picMk id="2" creationId="{AC574D1C-896E-D726-EE61-AC96A23637F3}"/>
          </ac:picMkLst>
        </pc:picChg>
        <pc:picChg chg="del">
          <ac:chgData name="Dominik Aumann" userId="013c187a20e8f01a" providerId="LiveId" clId="{C80A0E3D-4327-47AD-AF4E-C5A9CC23AC99}" dt="2024-02-26T00:01:21.699" v="175" actId="478"/>
          <ac:picMkLst>
            <pc:docMk/>
            <pc:sldMk cId="2120268309" sldId="258"/>
            <ac:picMk id="3" creationId="{DA76B1ED-EE20-3E00-A5A1-278636B3A9EF}"/>
          </ac:picMkLst>
        </pc:picChg>
        <pc:picChg chg="del mod">
          <ac:chgData name="Dominik Aumann" userId="013c187a20e8f01a" providerId="LiveId" clId="{C80A0E3D-4327-47AD-AF4E-C5A9CC23AC99}" dt="2024-02-26T00:01:20.434" v="174" actId="478"/>
          <ac:picMkLst>
            <pc:docMk/>
            <pc:sldMk cId="2120268309" sldId="258"/>
            <ac:picMk id="4" creationId="{AD1841C6-589F-355A-EE6A-3DAC7077C7FE}"/>
          </ac:picMkLst>
        </pc:picChg>
        <pc:picChg chg="add del mod">
          <ac:chgData name="Dominik Aumann" userId="013c187a20e8f01a" providerId="LiveId" clId="{C80A0E3D-4327-47AD-AF4E-C5A9CC23AC99}" dt="2024-02-25T23:55:31.197" v="113" actId="478"/>
          <ac:picMkLst>
            <pc:docMk/>
            <pc:sldMk cId="2120268309" sldId="258"/>
            <ac:picMk id="5" creationId="{C42D6823-B58D-D607-6CCE-0B88BE5A5975}"/>
          </ac:picMkLst>
        </pc:picChg>
        <pc:picChg chg="del mod">
          <ac:chgData name="Dominik Aumann" userId="013c187a20e8f01a" providerId="LiveId" clId="{C80A0E3D-4327-47AD-AF4E-C5A9CC23AC99}" dt="2024-02-26T00:01:20.434" v="174" actId="478"/>
          <ac:picMkLst>
            <pc:docMk/>
            <pc:sldMk cId="2120268309" sldId="258"/>
            <ac:picMk id="6" creationId="{2448235F-6768-7E67-D204-4891EE159970}"/>
          </ac:picMkLst>
        </pc:picChg>
        <pc:picChg chg="del">
          <ac:chgData name="Dominik Aumann" userId="013c187a20e8f01a" providerId="LiveId" clId="{C80A0E3D-4327-47AD-AF4E-C5A9CC23AC99}" dt="2024-02-25T23:55:36.523" v="115" actId="478"/>
          <ac:picMkLst>
            <pc:docMk/>
            <pc:sldMk cId="2120268309" sldId="258"/>
            <ac:picMk id="7" creationId="{8FEEB825-B69A-3EE5-60F5-4A3259BC65CA}"/>
          </ac:picMkLst>
        </pc:picChg>
        <pc:picChg chg="del mod">
          <ac:chgData name="Dominik Aumann" userId="013c187a20e8f01a" providerId="LiveId" clId="{C80A0E3D-4327-47AD-AF4E-C5A9CC23AC99}" dt="2024-02-26T00:01:20.434" v="174" actId="478"/>
          <ac:picMkLst>
            <pc:docMk/>
            <pc:sldMk cId="2120268309" sldId="258"/>
            <ac:picMk id="8" creationId="{6C532D73-74E9-A34F-D22C-C7AD1EE003D8}"/>
          </ac:picMkLst>
        </pc:picChg>
        <pc:picChg chg="del">
          <ac:chgData name="Dominik Aumann" userId="013c187a20e8f01a" providerId="LiveId" clId="{C80A0E3D-4327-47AD-AF4E-C5A9CC23AC99}" dt="2024-02-25T23:55:06.952" v="100" actId="478"/>
          <ac:picMkLst>
            <pc:docMk/>
            <pc:sldMk cId="2120268309" sldId="258"/>
            <ac:picMk id="9" creationId="{2B43D425-0766-D65A-3718-DA2BD4F210B0}"/>
          </ac:picMkLst>
        </pc:picChg>
        <pc:picChg chg="del">
          <ac:chgData name="Dominik Aumann" userId="013c187a20e8f01a" providerId="LiveId" clId="{C80A0E3D-4327-47AD-AF4E-C5A9CC23AC99}" dt="2024-02-25T23:55:08.905" v="101" actId="478"/>
          <ac:picMkLst>
            <pc:docMk/>
            <pc:sldMk cId="2120268309" sldId="258"/>
            <ac:picMk id="10" creationId="{84546AC3-9BF4-681D-3A17-429D09ED3019}"/>
          </ac:picMkLst>
        </pc:picChg>
        <pc:picChg chg="del">
          <ac:chgData name="Dominik Aumann" userId="013c187a20e8f01a" providerId="LiveId" clId="{C80A0E3D-4327-47AD-AF4E-C5A9CC23AC99}" dt="2024-02-25T23:55:10.092" v="102" actId="478"/>
          <ac:picMkLst>
            <pc:docMk/>
            <pc:sldMk cId="2120268309" sldId="258"/>
            <ac:picMk id="11" creationId="{5F3F9770-3D47-1846-FC78-E9A428B038F6}"/>
          </ac:picMkLst>
        </pc:picChg>
        <pc:picChg chg="del">
          <ac:chgData name="Dominik Aumann" userId="013c187a20e8f01a" providerId="LiveId" clId="{C80A0E3D-4327-47AD-AF4E-C5A9CC23AC99}" dt="2024-02-25T23:55:11.982" v="104" actId="478"/>
          <ac:picMkLst>
            <pc:docMk/>
            <pc:sldMk cId="2120268309" sldId="258"/>
            <ac:picMk id="13" creationId="{B6775087-E82E-EF9D-8D07-C2FE61C8E876}"/>
          </ac:picMkLst>
        </pc:picChg>
        <pc:picChg chg="add del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9" creationId="{B284CFD1-7C70-6225-8CAD-7384548F1D6C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24" creationId="{FD330559-69B4-2FDF-F918-072828A3E93C}"/>
          </ac:picMkLst>
        </pc:picChg>
        <pc:picChg chg="del mod">
          <ac:chgData name="Dominik Aumann" userId="013c187a20e8f01a" providerId="LiveId" clId="{C80A0E3D-4327-47AD-AF4E-C5A9CC23AC99}" dt="2024-02-26T00:01:17.153" v="172" actId="478"/>
          <ac:picMkLst>
            <pc:docMk/>
            <pc:sldMk cId="2120268309" sldId="258"/>
            <ac:picMk id="26" creationId="{50B2A602-E250-66DD-19F0-DCA0C26E914C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32" creationId="{8E5D2B29-6A57-545C-61F2-7017D051C8C5}"/>
          </ac:picMkLst>
        </pc:picChg>
        <pc:picChg chg="del mod">
          <ac:chgData name="Dominik Aumann" userId="013c187a20e8f01a" providerId="LiveId" clId="{C80A0E3D-4327-47AD-AF4E-C5A9CC23AC99}" dt="2024-02-26T00:01:17.731" v="173" actId="478"/>
          <ac:picMkLst>
            <pc:docMk/>
            <pc:sldMk cId="2120268309" sldId="258"/>
            <ac:picMk id="33" creationId="{833A3CCC-626A-DDD4-8317-07A331F7C163}"/>
          </ac:picMkLst>
        </pc:picChg>
        <pc:picChg chg="del mod">
          <ac:chgData name="Dominik Aumann" userId="013c187a20e8f01a" providerId="LiveId" clId="{C80A0E3D-4327-47AD-AF4E-C5A9CC23AC99}" dt="2024-02-26T00:01:20.434" v="174" actId="478"/>
          <ac:picMkLst>
            <pc:docMk/>
            <pc:sldMk cId="2120268309" sldId="258"/>
            <ac:picMk id="45" creationId="{801E28F5-D7D1-FC6D-E86A-682665E78256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58" creationId="{9E92FC1C-1CE5-CA41-0D72-0EDFE50A1259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67" creationId="{0C86B721-3BF1-1009-F8B4-3C04FA69D113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68" creationId="{56E2149C-B14A-EA37-ADAC-94EDD4F9FC6D}"/>
          </ac:picMkLst>
        </pc:picChg>
        <pc:picChg chg="del">
          <ac:chgData name="Dominik Aumann" userId="013c187a20e8f01a" providerId="LiveId" clId="{C80A0E3D-4327-47AD-AF4E-C5A9CC23AC99}" dt="2024-02-25T23:55:05.312" v="99" actId="478"/>
          <ac:picMkLst>
            <pc:docMk/>
            <pc:sldMk cId="2120268309" sldId="258"/>
            <ac:picMk id="76" creationId="{8D6BE2B8-80CC-541E-D8C2-8924FC131C13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77" creationId="{AD6CF3FD-4C3A-70BC-CF6F-D51AE03947C4}"/>
          </ac:picMkLst>
        </pc:picChg>
        <pc:picChg chg="del">
          <ac:chgData name="Dominik Aumann" userId="013c187a20e8f01a" providerId="LiveId" clId="{C80A0E3D-4327-47AD-AF4E-C5A9CC23AC99}" dt="2024-02-25T23:55:10.826" v="103" actId="478"/>
          <ac:picMkLst>
            <pc:docMk/>
            <pc:sldMk cId="2120268309" sldId="258"/>
            <ac:picMk id="78" creationId="{B8E2D5D5-A926-7A47-05B6-601E42AB450B}"/>
          </ac:picMkLst>
        </pc:picChg>
        <pc:picChg chg="del mod">
          <ac:chgData name="Dominik Aumann" userId="013c187a20e8f01a" providerId="LiveId" clId="{C80A0E3D-4327-47AD-AF4E-C5A9CC23AC99}" dt="2024-02-26T00:01:20.434" v="174" actId="478"/>
          <ac:picMkLst>
            <pc:docMk/>
            <pc:sldMk cId="2120268309" sldId="258"/>
            <ac:picMk id="79" creationId="{5531E920-D3AD-F1EE-2D11-C2A4923D40B9}"/>
          </ac:picMkLst>
        </pc:picChg>
        <pc:picChg chg="mod">
          <ac:chgData name="Dominik Aumann" userId="013c187a20e8f01a" providerId="LiveId" clId="{C80A0E3D-4327-47AD-AF4E-C5A9CC23AC99}" dt="2024-02-26T00:38:37.627" v="940" actId="1076"/>
          <ac:picMkLst>
            <pc:docMk/>
            <pc:sldMk cId="2120268309" sldId="258"/>
            <ac:picMk id="84" creationId="{C35E3F10-996E-2A5E-180D-A156D871B8E5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85" creationId="{B37EB657-ABC7-DA62-8996-E9CA9B013610}"/>
          </ac:picMkLst>
        </pc:picChg>
        <pc:picChg chg="add del mod">
          <ac:chgData name="Dominik Aumann" userId="013c187a20e8f01a" providerId="LiveId" clId="{C80A0E3D-4327-47AD-AF4E-C5A9CC23AC99}" dt="2024-02-26T00:08:23.143" v="332" actId="21"/>
          <ac:picMkLst>
            <pc:docMk/>
            <pc:sldMk cId="2120268309" sldId="258"/>
            <ac:picMk id="93" creationId="{310A52E4-CE42-2C3B-204D-DCD246EA8656}"/>
          </ac:picMkLst>
        </pc:picChg>
        <pc:picChg chg="add del mod">
          <ac:chgData name="Dominik Aumann" userId="013c187a20e8f01a" providerId="LiveId" clId="{C80A0E3D-4327-47AD-AF4E-C5A9CC23AC99}" dt="2024-02-26T00:08:23.143" v="332" actId="21"/>
          <ac:picMkLst>
            <pc:docMk/>
            <pc:sldMk cId="2120268309" sldId="258"/>
            <ac:picMk id="94" creationId="{627E6BFD-4079-E1EE-AEA5-76B3DC4B70BA}"/>
          </ac:picMkLst>
        </pc:picChg>
        <pc:picChg chg="add del mod">
          <ac:chgData name="Dominik Aumann" userId="013c187a20e8f01a" providerId="LiveId" clId="{C80A0E3D-4327-47AD-AF4E-C5A9CC23AC99}" dt="2024-02-26T00:18:03.786" v="567" actId="478"/>
          <ac:picMkLst>
            <pc:docMk/>
            <pc:sldMk cId="2120268309" sldId="258"/>
            <ac:picMk id="124" creationId="{447F1E85-0115-D181-E268-21F90FA8EE2A}"/>
          </ac:picMkLst>
        </pc:picChg>
        <pc:picChg chg="add del mod">
          <ac:chgData name="Dominik Aumann" userId="013c187a20e8f01a" providerId="LiveId" clId="{C80A0E3D-4327-47AD-AF4E-C5A9CC23AC99}" dt="2024-02-26T00:18:29.006" v="577" actId="478"/>
          <ac:picMkLst>
            <pc:docMk/>
            <pc:sldMk cId="2120268309" sldId="258"/>
            <ac:picMk id="125" creationId="{FD7C919D-1F79-7611-B320-D757FD2967D3}"/>
          </ac:picMkLst>
        </pc:picChg>
        <pc:picChg chg="add del mod">
          <ac:chgData name="Dominik Aumann" userId="013c187a20e8f01a" providerId="LiveId" clId="{C80A0E3D-4327-47AD-AF4E-C5A9CC23AC99}" dt="2024-02-26T00:16:24.700" v="546" actId="478"/>
          <ac:picMkLst>
            <pc:docMk/>
            <pc:sldMk cId="2120268309" sldId="258"/>
            <ac:picMk id="126" creationId="{DDDE904F-35B1-9678-06F3-5BC7F3E4336D}"/>
          </ac:picMkLst>
        </pc:picChg>
        <pc:picChg chg="add del mod">
          <ac:chgData name="Dominik Aumann" userId="013c187a20e8f01a" providerId="LiveId" clId="{C80A0E3D-4327-47AD-AF4E-C5A9CC23AC99}" dt="2024-02-26T00:16:35.823" v="550" actId="478"/>
          <ac:picMkLst>
            <pc:docMk/>
            <pc:sldMk cId="2120268309" sldId="258"/>
            <ac:picMk id="127" creationId="{A5500663-289B-2D76-78AA-2163858B7BEB}"/>
          </ac:picMkLst>
        </pc:picChg>
        <pc:picChg chg="add del mod">
          <ac:chgData name="Dominik Aumann" userId="013c187a20e8f01a" providerId="LiveId" clId="{C80A0E3D-4327-47AD-AF4E-C5A9CC23AC99}" dt="2024-02-26T00:18:47.596" v="578" actId="478"/>
          <ac:picMkLst>
            <pc:docMk/>
            <pc:sldMk cId="2120268309" sldId="258"/>
            <ac:picMk id="128" creationId="{4CBE0789-5F05-B158-7F8E-30986A061F90}"/>
          </ac:picMkLst>
        </pc:picChg>
        <pc:picChg chg="add del mod">
          <ac:chgData name="Dominik Aumann" userId="013c187a20e8f01a" providerId="LiveId" clId="{C80A0E3D-4327-47AD-AF4E-C5A9CC23AC99}" dt="2024-02-26T00:17:41.120" v="558" actId="478"/>
          <ac:picMkLst>
            <pc:docMk/>
            <pc:sldMk cId="2120268309" sldId="258"/>
            <ac:picMk id="129" creationId="{28F922B6-39B0-8CBB-5A10-21888D1EF1B8}"/>
          </ac:picMkLst>
        </pc:picChg>
        <pc:picChg chg="add del mod">
          <ac:chgData name="Dominik Aumann" userId="013c187a20e8f01a" providerId="LiveId" clId="{C80A0E3D-4327-47AD-AF4E-C5A9CC23AC99}" dt="2024-02-26T00:17:53.601" v="563" actId="478"/>
          <ac:picMkLst>
            <pc:docMk/>
            <pc:sldMk cId="2120268309" sldId="258"/>
            <ac:picMk id="130" creationId="{E41F8C69-03A7-5339-96F6-DF97A60F21C4}"/>
          </ac:picMkLst>
        </pc:picChg>
        <pc:picChg chg="add del mod">
          <ac:chgData name="Dominik Aumann" userId="013c187a20e8f01a" providerId="LiveId" clId="{C80A0E3D-4327-47AD-AF4E-C5A9CC23AC99}" dt="2024-02-26T00:18:15.939" v="572" actId="478"/>
          <ac:picMkLst>
            <pc:docMk/>
            <pc:sldMk cId="2120268309" sldId="258"/>
            <ac:picMk id="131" creationId="{5AAD73D5-BFA1-6E75-4641-D52F3171F09A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2" creationId="{310A52E4-CE42-2C3B-204D-DCD246EA8656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3" creationId="{627E6BFD-4079-E1EE-AEA5-76B3DC4B70BA}"/>
          </ac:picMkLst>
        </pc:picChg>
        <pc:picChg chg="add del mod">
          <ac:chgData name="Dominik Aumann" userId="013c187a20e8f01a" providerId="LiveId" clId="{C80A0E3D-4327-47AD-AF4E-C5A9CC23AC99}" dt="2024-02-26T00:17:29.341" v="554" actId="478"/>
          <ac:picMkLst>
            <pc:docMk/>
            <pc:sldMk cId="2120268309" sldId="258"/>
            <ac:picMk id="134" creationId="{8054D3D4-48AF-A4D2-DEEB-4E04059A4644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5" creationId="{8152F9A4-CDAD-CE04-0032-06C8404E5A34}"/>
          </ac:picMkLst>
        </pc:picChg>
        <pc:picChg chg="add mod or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6" creationId="{3958AC26-E1C6-B46F-A705-E3CD47FD6E53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7" creationId="{BF8DEC6E-77F0-447F-3FD9-386E94E0137B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8" creationId="{16252424-273C-F778-8D80-5C0E79207338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39" creationId="{31C64126-B8C0-6E3A-F826-CDCCF94235C4}"/>
          </ac:picMkLst>
        </pc:picChg>
        <pc:picChg chg="add mod">
          <ac:chgData name="Dominik Aumann" userId="013c187a20e8f01a" providerId="LiveId" clId="{C80A0E3D-4327-47AD-AF4E-C5A9CC23AC99}" dt="2024-02-26T00:36:45.466" v="901" actId="1036"/>
          <ac:picMkLst>
            <pc:docMk/>
            <pc:sldMk cId="2120268309" sldId="258"/>
            <ac:picMk id="141" creationId="{73457BE7-7579-117C-BC62-38FA653C09B3}"/>
          </ac:picMkLst>
        </pc:picChg>
        <pc:cxnChg chg="del">
          <ac:chgData name="Dominik Aumann" userId="013c187a20e8f01a" providerId="LiveId" clId="{C80A0E3D-4327-47AD-AF4E-C5A9CC23AC99}" dt="2024-02-25T23:55:16.091" v="105" actId="478"/>
          <ac:cxnSpMkLst>
            <pc:docMk/>
            <pc:sldMk cId="2120268309" sldId="258"/>
            <ac:cxnSpMk id="14" creationId="{D6D1E10A-7B99-B39F-4EE3-9C84789138CD}"/>
          </ac:cxnSpMkLst>
        </pc:cxnChg>
        <pc:cxnChg chg="del">
          <ac:chgData name="Dominik Aumann" userId="013c187a20e8f01a" providerId="LiveId" clId="{C80A0E3D-4327-47AD-AF4E-C5A9CC23AC99}" dt="2024-02-25T23:55:17.169" v="106" actId="478"/>
          <ac:cxnSpMkLst>
            <pc:docMk/>
            <pc:sldMk cId="2120268309" sldId="258"/>
            <ac:cxnSpMk id="25" creationId="{4BD6E9D3-85E8-B0F1-2E88-D7CF4C003936}"/>
          </ac:cxnSpMkLst>
        </pc:cxnChg>
        <pc:cxnChg chg="del">
          <ac:chgData name="Dominik Aumann" userId="013c187a20e8f01a" providerId="LiveId" clId="{C80A0E3D-4327-47AD-AF4E-C5A9CC23AC99}" dt="2024-02-25T23:55:18.949" v="108" actId="478"/>
          <ac:cxnSpMkLst>
            <pc:docMk/>
            <pc:sldMk cId="2120268309" sldId="258"/>
            <ac:cxnSpMk id="40" creationId="{D4FB7FF5-6B57-470A-4699-2741FE8C7149}"/>
          </ac:cxnSpMkLst>
        </pc:cxnChg>
        <pc:cxnChg chg="mod">
          <ac:chgData name="Dominik Aumann" userId="013c187a20e8f01a" providerId="LiveId" clId="{C80A0E3D-4327-47AD-AF4E-C5A9CC23AC99}" dt="2024-02-26T00:40:53.735" v="974" actId="1036"/>
          <ac:cxnSpMkLst>
            <pc:docMk/>
            <pc:sldMk cId="2120268309" sldId="258"/>
            <ac:cxnSpMk id="41" creationId="{6245267B-9BF4-2EFD-1387-26E1FB7FD54A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42" creationId="{520FEFAD-3AA8-B991-9266-6D93957DB8C5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43" creationId="{8D86AA4D-2BCC-2159-5B3A-D8D5FC12C2A0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44" creationId="{03950941-FF5C-603E-B69C-D06AA742F9FC}"/>
          </ac:cxnSpMkLst>
        </pc:cxnChg>
        <pc:cxnChg chg="del">
          <ac:chgData name="Dominik Aumann" userId="013c187a20e8f01a" providerId="LiveId" clId="{C80A0E3D-4327-47AD-AF4E-C5A9CC23AC99}" dt="2024-02-25T23:55:20.012" v="109" actId="478"/>
          <ac:cxnSpMkLst>
            <pc:docMk/>
            <pc:sldMk cId="2120268309" sldId="258"/>
            <ac:cxnSpMk id="51" creationId="{84E5D1D2-7FBE-F800-8AC1-8222DB7AE0C0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52" creationId="{DF825B31-761D-FD09-F8DB-B716F9AB4E60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59" creationId="{EDB9EC2B-0769-3B5A-22B0-23E63083B417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65" creationId="{03371B3C-5A7E-DA79-D37C-930948406105}"/>
          </ac:cxnSpMkLst>
        </pc:cxnChg>
        <pc:cxnChg chg="del">
          <ac:chgData name="Dominik Aumann" userId="013c187a20e8f01a" providerId="LiveId" clId="{C80A0E3D-4327-47AD-AF4E-C5A9CC23AC99}" dt="2024-02-26T00:01:21.699" v="175" actId="478"/>
          <ac:cxnSpMkLst>
            <pc:docMk/>
            <pc:sldMk cId="2120268309" sldId="258"/>
            <ac:cxnSpMk id="66" creationId="{2E05DF4F-9B46-6FD4-2DFF-6086859842A0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74" creationId="{0CE133B2-5746-F10A-00CA-C36D1D87BAF7}"/>
          </ac:cxnSpMkLst>
        </pc:cxnChg>
        <pc:cxnChg chg="del">
          <ac:chgData name="Dominik Aumann" userId="013c187a20e8f01a" providerId="LiveId" clId="{C80A0E3D-4327-47AD-AF4E-C5A9CC23AC99}" dt="2024-02-25T23:55:22.605" v="110" actId="478"/>
          <ac:cxnSpMkLst>
            <pc:docMk/>
            <pc:sldMk cId="2120268309" sldId="258"/>
            <ac:cxnSpMk id="75" creationId="{71FCB21E-F3FD-5FAF-83F2-2391FDF89689}"/>
          </ac:cxnSpMkLst>
        </pc:cxnChg>
        <pc:cxnChg chg="del">
          <ac:chgData name="Dominik Aumann" userId="013c187a20e8f01a" providerId="LiveId" clId="{C80A0E3D-4327-47AD-AF4E-C5A9CC23AC99}" dt="2024-02-26T00:01:20.434" v="174" actId="478"/>
          <ac:cxnSpMkLst>
            <pc:docMk/>
            <pc:sldMk cId="2120268309" sldId="258"/>
            <ac:cxnSpMk id="80" creationId="{CB6A9CDB-25CE-6EC4-771C-A90F668EEA50}"/>
          </ac:cxnSpMkLst>
        </pc:cxnChg>
        <pc:cxnChg chg="del mod">
          <ac:chgData name="Dominik Aumann" userId="013c187a20e8f01a" providerId="LiveId" clId="{C80A0E3D-4327-47AD-AF4E-C5A9CC23AC99}" dt="2024-02-25T23:55:38.070" v="117" actId="478"/>
          <ac:cxnSpMkLst>
            <pc:docMk/>
            <pc:sldMk cId="2120268309" sldId="258"/>
            <ac:cxnSpMk id="81" creationId="{98BDAACC-59C5-BBD5-098D-3F25B4BD1146}"/>
          </ac:cxnSpMkLst>
        </pc:cxnChg>
        <pc:cxnChg chg="del">
          <ac:chgData name="Dominik Aumann" userId="013c187a20e8f01a" providerId="LiveId" clId="{C80A0E3D-4327-47AD-AF4E-C5A9CC23AC99}" dt="2024-02-25T23:55:18.121" v="107" actId="478"/>
          <ac:cxnSpMkLst>
            <pc:docMk/>
            <pc:sldMk cId="2120268309" sldId="258"/>
            <ac:cxnSpMk id="82" creationId="{D8CFE089-2B90-F319-E4B9-67DF5EFF61C1}"/>
          </ac:cxnSpMkLst>
        </pc:cxnChg>
        <pc:cxnChg chg="add del mod">
          <ac:chgData name="Dominik Aumann" userId="013c187a20e8f01a" providerId="LiveId" clId="{C80A0E3D-4327-47AD-AF4E-C5A9CC23AC99}" dt="2024-02-26T00:07:59.867" v="327" actId="478"/>
          <ac:cxnSpMkLst>
            <pc:docMk/>
            <pc:sldMk cId="2120268309" sldId="258"/>
            <ac:cxnSpMk id="86" creationId="{D6C35400-8652-654C-10A3-98A2495DF23A}"/>
          </ac:cxnSpMkLst>
        </pc:cxnChg>
        <pc:cxnChg chg="add del mod">
          <ac:chgData name="Dominik Aumann" userId="013c187a20e8f01a" providerId="LiveId" clId="{C80A0E3D-4327-47AD-AF4E-C5A9CC23AC99}" dt="2024-02-26T00:07:58.602" v="326" actId="478"/>
          <ac:cxnSpMkLst>
            <pc:docMk/>
            <pc:sldMk cId="2120268309" sldId="258"/>
            <ac:cxnSpMk id="87" creationId="{15DEAB76-8B80-ECE0-9E13-8B2EB1C61E07}"/>
          </ac:cxnSpMkLst>
        </pc:cxnChg>
        <pc:cxnChg chg="add del mod">
          <ac:chgData name="Dominik Aumann" userId="013c187a20e8f01a" providerId="LiveId" clId="{C80A0E3D-4327-47AD-AF4E-C5A9CC23AC99}" dt="2024-02-26T00:07:57.774" v="325" actId="478"/>
          <ac:cxnSpMkLst>
            <pc:docMk/>
            <pc:sldMk cId="2120268309" sldId="258"/>
            <ac:cxnSpMk id="88" creationId="{28975D1D-2DE7-3A33-07D2-D6ADCA4CF40D}"/>
          </ac:cxnSpMkLst>
        </pc:cxnChg>
        <pc:cxnChg chg="add del mod">
          <ac:chgData name="Dominik Aumann" userId="013c187a20e8f01a" providerId="LiveId" clId="{C80A0E3D-4327-47AD-AF4E-C5A9CC23AC99}" dt="2024-02-26T00:07:57.024" v="324" actId="478"/>
          <ac:cxnSpMkLst>
            <pc:docMk/>
            <pc:sldMk cId="2120268309" sldId="258"/>
            <ac:cxnSpMk id="89" creationId="{03C07F83-FA22-DEED-1F3D-A94D153FFDC6}"/>
          </ac:cxnSpMkLst>
        </pc:cxnChg>
        <pc:cxnChg chg="add del mod">
          <ac:chgData name="Dominik Aumann" userId="013c187a20e8f01a" providerId="LiveId" clId="{C80A0E3D-4327-47AD-AF4E-C5A9CC23AC99}" dt="2024-02-26T00:07:56.259" v="323" actId="478"/>
          <ac:cxnSpMkLst>
            <pc:docMk/>
            <pc:sldMk cId="2120268309" sldId="258"/>
            <ac:cxnSpMk id="90" creationId="{1BFEF5FD-C254-84F8-6F00-C499EA1C92BD}"/>
          </ac:cxnSpMkLst>
        </pc:cxnChg>
        <pc:cxnChg chg="add del mod">
          <ac:chgData name="Dominik Aumann" userId="013c187a20e8f01a" providerId="LiveId" clId="{C80A0E3D-4327-47AD-AF4E-C5A9CC23AC99}" dt="2024-02-26T00:07:55.478" v="322" actId="478"/>
          <ac:cxnSpMkLst>
            <pc:docMk/>
            <pc:sldMk cId="2120268309" sldId="258"/>
            <ac:cxnSpMk id="91" creationId="{CC7035EE-801D-8F27-2965-C3999D46DA38}"/>
          </ac:cxnSpMkLst>
        </pc:cxnChg>
        <pc:cxnChg chg="add del mod">
          <ac:chgData name="Dominik Aumann" userId="013c187a20e8f01a" providerId="LiveId" clId="{C80A0E3D-4327-47AD-AF4E-C5A9CC23AC99}" dt="2024-02-26T00:07:54.072" v="321" actId="478"/>
          <ac:cxnSpMkLst>
            <pc:docMk/>
            <pc:sldMk cId="2120268309" sldId="258"/>
            <ac:cxnSpMk id="92" creationId="{861386EC-7DBA-35FF-3CB6-9FB6A83FC4BA}"/>
          </ac:cxnSpMkLst>
        </pc:cxnChg>
        <pc:cxnChg chg="add mod">
          <ac:chgData name="Dominik Aumann" userId="013c187a20e8f01a" providerId="LiveId" clId="{C80A0E3D-4327-47AD-AF4E-C5A9CC23AC99}" dt="2024-02-26T00:41:02.999" v="985" actId="1036"/>
          <ac:cxnSpMkLst>
            <pc:docMk/>
            <pc:sldMk cId="2120268309" sldId="258"/>
            <ac:cxnSpMk id="97" creationId="{11C8406A-9067-4241-FEC3-357A7D0F0E66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2" creationId="{0C1DA768-0DED-2D1E-7573-43C5EF7440B4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4" creationId="{166E61D1-CC32-FAAE-9FF8-1164D56437F9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5" creationId="{B07F3611-9EBC-F54A-91A2-14917CEEB020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6" creationId="{2376100E-A9E2-A9D2-426D-85D2C83353EE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7" creationId="{857EB53C-8FA7-340B-371B-734E9E219ED7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8" creationId="{A15FFA81-AC84-19FC-01B0-E11B2FDCE227}"/>
          </ac:cxnSpMkLst>
        </pc:cxnChg>
        <pc:cxnChg chg="add mod">
          <ac:chgData name="Dominik Aumann" userId="013c187a20e8f01a" providerId="LiveId" clId="{C80A0E3D-4327-47AD-AF4E-C5A9CC23AC99}" dt="2024-02-26T00:36:45.466" v="901" actId="1036"/>
          <ac:cxnSpMkLst>
            <pc:docMk/>
            <pc:sldMk cId="2120268309" sldId="258"/>
            <ac:cxnSpMk id="169" creationId="{D0443850-33A2-4543-F691-8AF9F3F7D73F}"/>
          </ac:cxnSpMkLst>
        </pc:cxnChg>
        <pc:cxnChg chg="add mod">
          <ac:chgData name="Dominik Aumann" userId="013c187a20e8f01a" providerId="LiveId" clId="{C80A0E3D-4327-47AD-AF4E-C5A9CC23AC99}" dt="2024-02-26T00:38:36.127" v="939" actId="1036"/>
          <ac:cxnSpMkLst>
            <pc:docMk/>
            <pc:sldMk cId="2120268309" sldId="258"/>
            <ac:cxnSpMk id="170" creationId="{51EE7AA3-83DA-DAF0-637D-44C7ABDC9DDB}"/>
          </ac:cxnSpMkLst>
        </pc:cxnChg>
        <pc:cxnChg chg="add mod">
          <ac:chgData name="Dominik Aumann" userId="013c187a20e8f01a" providerId="LiveId" clId="{C80A0E3D-4327-47AD-AF4E-C5A9CC23AC99}" dt="2024-02-26T00:41:13.372" v="996" actId="1036"/>
          <ac:cxnSpMkLst>
            <pc:docMk/>
            <pc:sldMk cId="2120268309" sldId="258"/>
            <ac:cxnSpMk id="171" creationId="{3275829D-C7B5-DF67-BCA0-4D4F75C62A57}"/>
          </ac:cxnSpMkLst>
        </pc:cxnChg>
        <pc:cxnChg chg="add mod">
          <ac:chgData name="Dominik Aumann" userId="013c187a20e8f01a" providerId="LiveId" clId="{C80A0E3D-4327-47AD-AF4E-C5A9CC23AC99}" dt="2024-02-26T00:41:24.259" v="1039" actId="1038"/>
          <ac:cxnSpMkLst>
            <pc:docMk/>
            <pc:sldMk cId="2120268309" sldId="258"/>
            <ac:cxnSpMk id="172" creationId="{027C7710-3F5C-216B-003D-68D4EE4C43B3}"/>
          </ac:cxnSpMkLst>
        </pc:cxnChg>
        <pc:cxnChg chg="add mod">
          <ac:chgData name="Dominik Aumann" userId="013c187a20e8f01a" providerId="LiveId" clId="{C80A0E3D-4327-47AD-AF4E-C5A9CC23AC99}" dt="2024-02-26T00:41:34.429" v="1069" actId="1038"/>
          <ac:cxnSpMkLst>
            <pc:docMk/>
            <pc:sldMk cId="2120268309" sldId="258"/>
            <ac:cxnSpMk id="173" creationId="{6F6EEDB3-2FE3-5684-74AF-D85A4469198A}"/>
          </ac:cxnSpMkLst>
        </pc:cxnChg>
        <pc:cxnChg chg="add mod">
          <ac:chgData name="Dominik Aumann" userId="013c187a20e8f01a" providerId="LiveId" clId="{C80A0E3D-4327-47AD-AF4E-C5A9CC23AC99}" dt="2024-02-26T00:41:44.114" v="1113" actId="1038"/>
          <ac:cxnSpMkLst>
            <pc:docMk/>
            <pc:sldMk cId="2120268309" sldId="258"/>
            <ac:cxnSpMk id="174" creationId="{D10FCEF2-C2A4-2DE7-A9F5-C66EA3AC627B}"/>
          </ac:cxnSpMkLst>
        </pc:cxnChg>
        <pc:cxnChg chg="add mod">
          <ac:chgData name="Dominik Aumann" userId="013c187a20e8f01a" providerId="LiveId" clId="{C80A0E3D-4327-47AD-AF4E-C5A9CC23AC99}" dt="2024-02-26T00:41:55.596" v="1142" actId="1038"/>
          <ac:cxnSpMkLst>
            <pc:docMk/>
            <pc:sldMk cId="2120268309" sldId="258"/>
            <ac:cxnSpMk id="175" creationId="{EA9CAC88-3DEF-03F4-A2F6-7BA75521ED85}"/>
          </ac:cxnSpMkLst>
        </pc:cxnChg>
        <pc:cxnChg chg="add mod">
          <ac:chgData name="Dominik Aumann" userId="013c187a20e8f01a" providerId="LiveId" clId="{C80A0E3D-4327-47AD-AF4E-C5A9CC23AC99}" dt="2024-02-26T00:42:11.217" v="1207" actId="1037"/>
          <ac:cxnSpMkLst>
            <pc:docMk/>
            <pc:sldMk cId="2120268309" sldId="258"/>
            <ac:cxnSpMk id="176" creationId="{C4F9F35A-54AA-C59D-A1BC-81E8A55EA7FA}"/>
          </ac:cxnSpMkLst>
        </pc:cxnChg>
      </pc:sldChg>
      <pc:sldChg chg="delSp add del mod">
        <pc:chgData name="Dominik Aumann" userId="013c187a20e8f01a" providerId="LiveId" clId="{C80A0E3D-4327-47AD-AF4E-C5A9CC23AC99}" dt="2024-02-26T00:10:16.257" v="384" actId="47"/>
        <pc:sldMkLst>
          <pc:docMk/>
          <pc:sldMk cId="2218060815" sldId="259"/>
        </pc:sldMkLst>
        <pc:picChg chg="del">
          <ac:chgData name="Dominik Aumann" userId="013c187a20e8f01a" providerId="LiveId" clId="{C80A0E3D-4327-47AD-AF4E-C5A9CC23AC99}" dt="2024-02-26T00:06:31.607" v="307" actId="21"/>
          <ac:picMkLst>
            <pc:docMk/>
            <pc:sldMk cId="2218060815" sldId="259"/>
            <ac:picMk id="2" creationId="{627E6BFD-4079-E1EE-AEA5-76B3DC4B70BA}"/>
          </ac:picMkLst>
        </pc:picChg>
        <pc:picChg chg="del">
          <ac:chgData name="Dominik Aumann" userId="013c187a20e8f01a" providerId="LiveId" clId="{C80A0E3D-4327-47AD-AF4E-C5A9CC23AC99}" dt="2024-02-26T00:06:31.607" v="307" actId="21"/>
          <ac:picMkLst>
            <pc:docMk/>
            <pc:sldMk cId="2218060815" sldId="259"/>
            <ac:picMk id="3" creationId="{310A52E4-CE42-2C3B-204D-DCD246EA8656}"/>
          </ac:picMkLst>
        </pc:picChg>
        <pc:picChg chg="del">
          <ac:chgData name="Dominik Aumann" userId="013c187a20e8f01a" providerId="LiveId" clId="{C80A0E3D-4327-47AD-AF4E-C5A9CC23AC99}" dt="2024-02-26T00:02:49.116" v="195" actId="21"/>
          <ac:picMkLst>
            <pc:docMk/>
            <pc:sldMk cId="2218060815" sldId="259"/>
            <ac:picMk id="4" creationId="{AD6CF3FD-4C3A-70BC-CF6F-D51AE03947C4}"/>
          </ac:picMkLst>
        </pc:picChg>
        <pc:picChg chg="del">
          <ac:chgData name="Dominik Aumann" userId="013c187a20e8f01a" providerId="LiveId" clId="{C80A0E3D-4327-47AD-AF4E-C5A9CC23AC99}" dt="2024-02-26T00:02:37.556" v="192" actId="21"/>
          <ac:picMkLst>
            <pc:docMk/>
            <pc:sldMk cId="2218060815" sldId="259"/>
            <ac:picMk id="6" creationId="{56E2149C-B14A-EA37-ADAC-94EDD4F9FC6D}"/>
          </ac:picMkLst>
        </pc:picChg>
        <pc:picChg chg="del">
          <ac:chgData name="Dominik Aumann" userId="013c187a20e8f01a" providerId="LiveId" clId="{C80A0E3D-4327-47AD-AF4E-C5A9CC23AC99}" dt="2024-02-26T00:02:16.842" v="188" actId="21"/>
          <ac:picMkLst>
            <pc:docMk/>
            <pc:sldMk cId="2218060815" sldId="259"/>
            <ac:picMk id="8" creationId="{0C86B721-3BF1-1009-F8B4-3C04FA69D113}"/>
          </ac:picMkLst>
        </pc:picChg>
        <pc:picChg chg="del">
          <ac:chgData name="Dominik Aumann" userId="013c187a20e8f01a" providerId="LiveId" clId="{C80A0E3D-4327-47AD-AF4E-C5A9CC23AC99}" dt="2024-02-26T00:01:27.120" v="176" actId="478"/>
          <ac:picMkLst>
            <pc:docMk/>
            <pc:sldMk cId="2218060815" sldId="259"/>
            <ac:picMk id="19" creationId="{0FD6825B-4610-DF5F-0F86-DCB8A33CE87F}"/>
          </ac:picMkLst>
        </pc:picChg>
        <pc:picChg chg="del">
          <ac:chgData name="Dominik Aumann" userId="013c187a20e8f01a" providerId="LiveId" clId="{C80A0E3D-4327-47AD-AF4E-C5A9CC23AC99}" dt="2024-02-26T00:01:57.956" v="181" actId="478"/>
          <ac:picMkLst>
            <pc:docMk/>
            <pc:sldMk cId="2218060815" sldId="259"/>
            <ac:picMk id="26" creationId="{D18E15DA-507E-9DD9-9D68-A85C27D3AC54}"/>
          </ac:picMkLst>
        </pc:picChg>
        <pc:picChg chg="del">
          <ac:chgData name="Dominik Aumann" userId="013c187a20e8f01a" providerId="LiveId" clId="{C80A0E3D-4327-47AD-AF4E-C5A9CC23AC99}" dt="2024-02-26T00:01:59.753" v="182" actId="21"/>
          <ac:picMkLst>
            <pc:docMk/>
            <pc:sldMk cId="2218060815" sldId="259"/>
            <ac:picMk id="33" creationId="{8E5D2B29-6A57-545C-61F2-7017D051C8C5}"/>
          </ac:picMkLst>
        </pc:picChg>
        <pc:picChg chg="del">
          <ac:chgData name="Dominik Aumann" userId="013c187a20e8f01a" providerId="LiveId" clId="{C80A0E3D-4327-47AD-AF4E-C5A9CC23AC99}" dt="2024-02-26T00:02:06.907" v="185" actId="21"/>
          <ac:picMkLst>
            <pc:docMk/>
            <pc:sldMk cId="2218060815" sldId="259"/>
            <ac:picMk id="45" creationId="{9E92FC1C-1CE5-CA41-0D72-0EDFE50A1259}"/>
          </ac:picMkLst>
        </pc:picChg>
        <pc:picChg chg="del">
          <ac:chgData name="Dominik Aumann" userId="013c187a20e8f01a" providerId="LiveId" clId="{C80A0E3D-4327-47AD-AF4E-C5A9CC23AC99}" dt="2024-02-26T00:03:04.253" v="198" actId="21"/>
          <ac:picMkLst>
            <pc:docMk/>
            <pc:sldMk cId="2218060815" sldId="259"/>
            <ac:picMk id="79" creationId="{B37EB657-ABC7-DA62-8996-E9CA9B013610}"/>
          </ac:picMkLst>
        </pc:picChg>
        <pc:cxnChg chg="del">
          <ac:chgData name="Dominik Aumann" userId="013c187a20e8f01a" providerId="LiveId" clId="{C80A0E3D-4327-47AD-AF4E-C5A9CC23AC99}" dt="2024-02-26T00:01:27.791" v="177" actId="478"/>
          <ac:cxnSpMkLst>
            <pc:docMk/>
            <pc:sldMk cId="2218060815" sldId="259"/>
            <ac:cxnSpMk id="41" creationId="{103F30B8-E3DA-A1B3-424A-491E1609814E}"/>
          </ac:cxnSpMkLst>
        </pc:cxnChg>
        <pc:cxnChg chg="del">
          <ac:chgData name="Dominik Aumann" userId="013c187a20e8f01a" providerId="LiveId" clId="{C80A0E3D-4327-47AD-AF4E-C5A9CC23AC99}" dt="2024-02-26T00:06:08.815" v="305" actId="478"/>
          <ac:cxnSpMkLst>
            <pc:docMk/>
            <pc:sldMk cId="2218060815" sldId="259"/>
            <ac:cxnSpMk id="43" creationId="{4670EAC0-0B54-874F-F051-B00F0E14F7BA}"/>
          </ac:cxnSpMkLst>
        </pc:cxnChg>
        <pc:cxnChg chg="del">
          <ac:chgData name="Dominik Aumann" userId="013c187a20e8f01a" providerId="LiveId" clId="{C80A0E3D-4327-47AD-AF4E-C5A9CC23AC99}" dt="2024-02-26T00:06:10.284" v="306" actId="478"/>
          <ac:cxnSpMkLst>
            <pc:docMk/>
            <pc:sldMk cId="2218060815" sldId="259"/>
            <ac:cxnSpMk id="44" creationId="{46BEFA34-B62A-0304-543E-FA04F0A03C55}"/>
          </ac:cxnSpMkLst>
        </pc:cxnChg>
        <pc:cxnChg chg="del">
          <ac:chgData name="Dominik Aumann" userId="013c187a20e8f01a" providerId="LiveId" clId="{C80A0E3D-4327-47AD-AF4E-C5A9CC23AC99}" dt="2024-02-26T00:06:10.284" v="306" actId="478"/>
          <ac:cxnSpMkLst>
            <pc:docMk/>
            <pc:sldMk cId="2218060815" sldId="259"/>
            <ac:cxnSpMk id="52" creationId="{0C923C63-6A7A-9D80-E751-1A6C5EE2D103}"/>
          </ac:cxnSpMkLst>
        </pc:cxnChg>
        <pc:cxnChg chg="del">
          <ac:chgData name="Dominik Aumann" userId="013c187a20e8f01a" providerId="LiveId" clId="{C80A0E3D-4327-47AD-AF4E-C5A9CC23AC99}" dt="2024-02-26T00:06:10.284" v="306" actId="478"/>
          <ac:cxnSpMkLst>
            <pc:docMk/>
            <pc:sldMk cId="2218060815" sldId="259"/>
            <ac:cxnSpMk id="59" creationId="{ADF91449-8B8F-3499-3DED-864EF54D9A18}"/>
          </ac:cxnSpMkLst>
        </pc:cxnChg>
        <pc:cxnChg chg="del">
          <ac:chgData name="Dominik Aumann" userId="013c187a20e8f01a" providerId="LiveId" clId="{C80A0E3D-4327-47AD-AF4E-C5A9CC23AC99}" dt="2024-02-26T00:06:10.284" v="306" actId="478"/>
          <ac:cxnSpMkLst>
            <pc:docMk/>
            <pc:sldMk cId="2218060815" sldId="259"/>
            <ac:cxnSpMk id="65" creationId="{6181A422-0A08-782F-42BE-038A53C0DB20}"/>
          </ac:cxnSpMkLst>
        </pc:cxnChg>
        <pc:cxnChg chg="del">
          <ac:chgData name="Dominik Aumann" userId="013c187a20e8f01a" providerId="LiveId" clId="{C80A0E3D-4327-47AD-AF4E-C5A9CC23AC99}" dt="2024-02-26T00:06:10.284" v="306" actId="478"/>
          <ac:cxnSpMkLst>
            <pc:docMk/>
            <pc:sldMk cId="2218060815" sldId="259"/>
            <ac:cxnSpMk id="74" creationId="{5A6A86BD-A939-B96F-6BC6-F601E6E7E62B}"/>
          </ac:cxnSpMkLst>
        </pc:cxnChg>
        <pc:cxnChg chg="del">
          <ac:chgData name="Dominik Aumann" userId="013c187a20e8f01a" providerId="LiveId" clId="{C80A0E3D-4327-47AD-AF4E-C5A9CC23AC99}" dt="2024-02-26T00:06:10.284" v="306" actId="478"/>
          <ac:cxnSpMkLst>
            <pc:docMk/>
            <pc:sldMk cId="2218060815" sldId="259"/>
            <ac:cxnSpMk id="80" creationId="{D9BC61CF-6A3A-6B41-13B0-688B847FCB12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3623EB-2540-4FDA-9A35-80B9598DACA9}" type="datetimeFigureOut">
              <a:rPr lang="de-AT" smtClean="0"/>
              <a:t>26.02.2024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771775" y="1143000"/>
            <a:ext cx="13144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4C19E9-5AF2-4066-96E0-1CF0ACEB01D5}" type="slidenum">
              <a:rPr lang="de-AT" smtClean="0"/>
              <a:t>‹Nr.›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2107043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A4C19E9-5AF2-4066-96E0-1CF0ACEB01D5}" type="slidenum">
              <a:rPr lang="de-AT" smtClean="0"/>
              <a:t>1</a:t>
            </a:fld>
            <a:endParaRPr lang="de-AT"/>
          </a:p>
        </p:txBody>
      </p:sp>
    </p:spTree>
    <p:extLst>
      <p:ext uri="{BB962C8B-B14F-4D97-AF65-F5344CB8AC3E}">
        <p14:creationId xmlns:p14="http://schemas.microsoft.com/office/powerpoint/2010/main" val="3344116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40068" y="5257022"/>
            <a:ext cx="6120765" cy="362742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80135" y="9589558"/>
            <a:ext cx="5040630" cy="432470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1051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0970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5220652" y="677696"/>
            <a:ext cx="1620203" cy="1443918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60045" y="677696"/>
            <a:ext cx="4740593" cy="1443918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4474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6428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68821" y="10874435"/>
            <a:ext cx="6120765" cy="336104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68821" y="7172585"/>
            <a:ext cx="6120765" cy="370185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572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60045" y="3948643"/>
            <a:ext cx="3180398" cy="111682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660457" y="3948643"/>
            <a:ext cx="3180398" cy="1116823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27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60045" y="3788033"/>
            <a:ext cx="3181648" cy="1578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60045" y="5366705"/>
            <a:ext cx="3181648" cy="975016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657957" y="3788033"/>
            <a:ext cx="3182898" cy="157867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657957" y="5366705"/>
            <a:ext cx="3182898" cy="975016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969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320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27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60046" y="673776"/>
            <a:ext cx="2369046" cy="286746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815352" y="673778"/>
            <a:ext cx="4025503" cy="14443098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60046" y="3541244"/>
            <a:ext cx="2369046" cy="1157563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218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411427" y="11845925"/>
            <a:ext cx="4320540" cy="139847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411427" y="1512079"/>
            <a:ext cx="4320540" cy="1015365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411427" y="13244403"/>
            <a:ext cx="4320540" cy="198607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6017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60045" y="677695"/>
            <a:ext cx="6480810" cy="282045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60045" y="3948643"/>
            <a:ext cx="6480810" cy="1116823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60045" y="15684883"/>
            <a:ext cx="1680210" cy="9009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BF663B-9B0A-4CF7-9C47-4166A885107B}" type="datetimeFigureOut">
              <a:rPr lang="en-US" smtClean="0"/>
              <a:t>2/26/2024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460308" y="15684883"/>
            <a:ext cx="2280285" cy="9009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5160645" y="15684883"/>
            <a:ext cx="1680210" cy="9009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318470-2704-48CF-A043-FA22C552AC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016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png"/><Relationship Id="rId18" Type="http://schemas.openxmlformats.org/officeDocument/2006/relationships/image" Target="../media/image15.png"/><Relationship Id="rId3" Type="http://schemas.openxmlformats.org/officeDocument/2006/relationships/image" Target="../media/image1.png"/><Relationship Id="rId21" Type="http://schemas.microsoft.com/office/2007/relationships/hdphoto" Target="../media/hdphoto2.wdp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17" Type="http://schemas.openxmlformats.org/officeDocument/2006/relationships/image" Target="../media/image14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png"/><Relationship Id="rId15" Type="http://schemas.openxmlformats.org/officeDocument/2006/relationships/image" Target="../media/image12.png"/><Relationship Id="rId10" Type="http://schemas.openxmlformats.org/officeDocument/2006/relationships/image" Target="../media/image8.tiff"/><Relationship Id="rId19" Type="http://schemas.openxmlformats.org/officeDocument/2006/relationships/image" Target="../media/image16.png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xmlns="" id="{0033B0FE-C5F4-EFA3-4A61-97A1D419134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6" name="Grafik 135" descr="Ein Bild, das Text, Reihe, Screenshot, Schrift enthält.&#10;&#10;Automatisch generierte Beschreibung">
            <a:extLst>
              <a:ext uri="{FF2B5EF4-FFF2-40B4-BE49-F238E27FC236}">
                <a16:creationId xmlns:a16="http://schemas.microsoft.com/office/drawing/2014/main" xmlns="" id="{3958AC26-E1C6-B46F-A705-E3CD47FD6E5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380" y="4586866"/>
            <a:ext cx="3250239" cy="1188000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xmlns="" id="{B284CFD1-7C70-6225-8CAD-7384548F1D6C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514" y="754993"/>
            <a:ext cx="3264272" cy="1224000"/>
          </a:xfrm>
          <a:prstGeom prst="rect">
            <a:avLst/>
          </a:prstGeom>
        </p:spPr>
      </p:pic>
      <p:cxnSp>
        <p:nvCxnSpPr>
          <p:cNvPr id="41" name="Gerade Verbindung 40">
            <a:extLst>
              <a:ext uri="{FF2B5EF4-FFF2-40B4-BE49-F238E27FC236}">
                <a16:creationId xmlns:a16="http://schemas.microsoft.com/office/drawing/2014/main" xmlns="" id="{6245267B-9BF4-2EFD-1387-26E1FB7FD54A}"/>
              </a:ext>
            </a:extLst>
          </p:cNvPr>
          <p:cNvCxnSpPr>
            <a:cxnSpLocks/>
          </p:cNvCxnSpPr>
          <p:nvPr/>
        </p:nvCxnSpPr>
        <p:spPr>
          <a:xfrm flipH="1">
            <a:off x="3899541" y="1388561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feld 1">
            <a:extLst>
              <a:ext uri="{FF2B5EF4-FFF2-40B4-BE49-F238E27FC236}">
                <a16:creationId xmlns:a16="http://schemas.microsoft.com/office/drawing/2014/main" xmlns="" id="{2833FD60-11A4-8CB0-C795-360AE17CAB2B}"/>
              </a:ext>
            </a:extLst>
          </p:cNvPr>
          <p:cNvSpPr txBox="1"/>
          <p:nvPr/>
        </p:nvSpPr>
        <p:spPr>
          <a:xfrm>
            <a:off x="5989759" y="201941"/>
            <a:ext cx="12057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de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dirty="0"/>
              <a:t>Suppl. Fig 2</a:t>
            </a:r>
          </a:p>
        </p:txBody>
      </p:sp>
      <p:pic>
        <p:nvPicPr>
          <p:cNvPr id="84" name="Picture 2">
            <a:extLst>
              <a:ext uri="{FF2B5EF4-FFF2-40B4-BE49-F238E27FC236}">
                <a16:creationId xmlns:a16="http://schemas.microsoft.com/office/drawing/2014/main" xmlns="" id="{C35E3F10-996E-2A5E-180D-A156D871B8E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3283" y="16022287"/>
            <a:ext cx="3732672" cy="648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" name="Grafik 23">
            <a:extLst>
              <a:ext uri="{FF2B5EF4-FFF2-40B4-BE49-F238E27FC236}">
                <a16:creationId xmlns:a16="http://schemas.microsoft.com/office/drawing/2014/main" xmlns="" id="{FD330559-69B4-2FDF-F918-072828A3E93C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0" y="2648760"/>
            <a:ext cx="3264306" cy="1224000"/>
          </a:xfrm>
          <a:prstGeom prst="rect">
            <a:avLst/>
          </a:prstGeom>
        </p:spPr>
      </p:pic>
      <p:pic>
        <p:nvPicPr>
          <p:cNvPr id="32" name="Grafik 31">
            <a:extLst>
              <a:ext uri="{FF2B5EF4-FFF2-40B4-BE49-F238E27FC236}">
                <a16:creationId xmlns:a16="http://schemas.microsoft.com/office/drawing/2014/main" xmlns="" id="{8E5D2B29-6A57-545C-61F2-7017D051C8C5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0" y="4586072"/>
            <a:ext cx="3264306" cy="1224000"/>
          </a:xfrm>
          <a:prstGeom prst="rect">
            <a:avLst/>
          </a:prstGeom>
        </p:spPr>
      </p:pic>
      <p:pic>
        <p:nvPicPr>
          <p:cNvPr id="58" name="Grafik 57">
            <a:extLst>
              <a:ext uri="{FF2B5EF4-FFF2-40B4-BE49-F238E27FC236}">
                <a16:creationId xmlns:a16="http://schemas.microsoft.com/office/drawing/2014/main" xmlns="" id="{9E92FC1C-1CE5-CA41-0D72-0EDFE50A1259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5" y="6523384"/>
            <a:ext cx="3264272" cy="1224000"/>
          </a:xfrm>
          <a:prstGeom prst="rect">
            <a:avLst/>
          </a:prstGeom>
        </p:spPr>
      </p:pic>
      <p:pic>
        <p:nvPicPr>
          <p:cNvPr id="67" name="Grafik 66">
            <a:extLst>
              <a:ext uri="{FF2B5EF4-FFF2-40B4-BE49-F238E27FC236}">
                <a16:creationId xmlns:a16="http://schemas.microsoft.com/office/drawing/2014/main" xmlns="" id="{0C86B721-3BF1-1009-F8B4-3C04FA69D113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5" y="8460696"/>
            <a:ext cx="3264272" cy="1224000"/>
          </a:xfrm>
          <a:prstGeom prst="rect">
            <a:avLst/>
          </a:prstGeom>
        </p:spPr>
      </p:pic>
      <p:pic>
        <p:nvPicPr>
          <p:cNvPr id="68" name="Grafik 67">
            <a:extLst>
              <a:ext uri="{FF2B5EF4-FFF2-40B4-BE49-F238E27FC236}">
                <a16:creationId xmlns:a16="http://schemas.microsoft.com/office/drawing/2014/main" xmlns="" id="{56E2149C-B14A-EA37-ADAC-94EDD4F9FC6D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0" y="10395333"/>
            <a:ext cx="3264306" cy="1224000"/>
          </a:xfrm>
          <a:prstGeom prst="rect">
            <a:avLst/>
          </a:prstGeom>
        </p:spPr>
      </p:pic>
      <p:pic>
        <p:nvPicPr>
          <p:cNvPr id="77" name="Grafik 76">
            <a:extLst>
              <a:ext uri="{FF2B5EF4-FFF2-40B4-BE49-F238E27FC236}">
                <a16:creationId xmlns:a16="http://schemas.microsoft.com/office/drawing/2014/main" xmlns="" id="{AD6CF3FD-4C3A-70BC-CF6F-D51AE03947C4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5" y="12329970"/>
            <a:ext cx="3264272" cy="1224000"/>
          </a:xfrm>
          <a:prstGeom prst="rect">
            <a:avLst/>
          </a:prstGeom>
        </p:spPr>
      </p:pic>
      <p:pic>
        <p:nvPicPr>
          <p:cNvPr id="85" name="Grafik 84">
            <a:extLst>
              <a:ext uri="{FF2B5EF4-FFF2-40B4-BE49-F238E27FC236}">
                <a16:creationId xmlns:a16="http://schemas.microsoft.com/office/drawing/2014/main" xmlns="" id="{B37EB657-ABC7-DA62-8996-E9CA9B013610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08480" y="14272102"/>
            <a:ext cx="3264306" cy="1224000"/>
          </a:xfrm>
          <a:prstGeom prst="rect">
            <a:avLst/>
          </a:prstGeom>
        </p:spPr>
      </p:pic>
      <p:cxnSp>
        <p:nvCxnSpPr>
          <p:cNvPr id="97" name="Gerade Verbindung 40">
            <a:extLst>
              <a:ext uri="{FF2B5EF4-FFF2-40B4-BE49-F238E27FC236}">
                <a16:creationId xmlns:a16="http://schemas.microsoft.com/office/drawing/2014/main" xmlns="" id="{11C8406A-9067-4241-FEC3-357A7D0F0E66}"/>
              </a:ext>
            </a:extLst>
          </p:cNvPr>
          <p:cNvCxnSpPr>
            <a:cxnSpLocks/>
          </p:cNvCxnSpPr>
          <p:nvPr/>
        </p:nvCxnSpPr>
        <p:spPr>
          <a:xfrm flipH="1">
            <a:off x="3903773" y="3284999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Textfeld 97">
            <a:extLst>
              <a:ext uri="{FF2B5EF4-FFF2-40B4-BE49-F238E27FC236}">
                <a16:creationId xmlns:a16="http://schemas.microsoft.com/office/drawing/2014/main" xmlns="" id="{F68F0C4D-D507-A071-2AD9-A1244ADE007F}"/>
              </a:ext>
            </a:extLst>
          </p:cNvPr>
          <p:cNvSpPr txBox="1"/>
          <p:nvPr/>
        </p:nvSpPr>
        <p:spPr>
          <a:xfrm>
            <a:off x="3806361" y="1926526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xmlns="" id="{F2462140-6A76-7D8C-C756-CCD4E74EA0A1}"/>
              </a:ext>
            </a:extLst>
          </p:cNvPr>
          <p:cNvSpPr txBox="1"/>
          <p:nvPr/>
        </p:nvSpPr>
        <p:spPr>
          <a:xfrm rot="16200000">
            <a:off x="3150705" y="1225343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0" name="Textfeld 99">
            <a:extLst>
              <a:ext uri="{FF2B5EF4-FFF2-40B4-BE49-F238E27FC236}">
                <a16:creationId xmlns:a16="http://schemas.microsoft.com/office/drawing/2014/main" xmlns="" id="{CA98E284-B8DB-BE43-1B89-FFDDF30C90A8}"/>
              </a:ext>
            </a:extLst>
          </p:cNvPr>
          <p:cNvSpPr txBox="1"/>
          <p:nvPr/>
        </p:nvSpPr>
        <p:spPr>
          <a:xfrm>
            <a:off x="3804237" y="3829323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1" name="Textfeld 100">
            <a:extLst>
              <a:ext uri="{FF2B5EF4-FFF2-40B4-BE49-F238E27FC236}">
                <a16:creationId xmlns:a16="http://schemas.microsoft.com/office/drawing/2014/main" xmlns="" id="{8A6825E9-1BD2-44B4-ADB9-056E17B5958A}"/>
              </a:ext>
            </a:extLst>
          </p:cNvPr>
          <p:cNvSpPr txBox="1"/>
          <p:nvPr/>
        </p:nvSpPr>
        <p:spPr>
          <a:xfrm rot="16200000">
            <a:off x="3148581" y="3114872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2" name="Textfeld 101">
            <a:extLst>
              <a:ext uri="{FF2B5EF4-FFF2-40B4-BE49-F238E27FC236}">
                <a16:creationId xmlns:a16="http://schemas.microsoft.com/office/drawing/2014/main" xmlns="" id="{12D91684-FE45-25ED-9342-CE5CA28A3464}"/>
              </a:ext>
            </a:extLst>
          </p:cNvPr>
          <p:cNvSpPr txBox="1"/>
          <p:nvPr/>
        </p:nvSpPr>
        <p:spPr>
          <a:xfrm>
            <a:off x="3804237" y="5744840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3" name="Textfeld 102">
            <a:extLst>
              <a:ext uri="{FF2B5EF4-FFF2-40B4-BE49-F238E27FC236}">
                <a16:creationId xmlns:a16="http://schemas.microsoft.com/office/drawing/2014/main" xmlns="" id="{D4DA3CB6-6E9D-5D1D-1B74-911CB472BF92}"/>
              </a:ext>
            </a:extLst>
          </p:cNvPr>
          <p:cNvSpPr txBox="1"/>
          <p:nvPr/>
        </p:nvSpPr>
        <p:spPr>
          <a:xfrm rot="16200000">
            <a:off x="3148581" y="5043657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4" name="Textfeld 103">
            <a:extLst>
              <a:ext uri="{FF2B5EF4-FFF2-40B4-BE49-F238E27FC236}">
                <a16:creationId xmlns:a16="http://schemas.microsoft.com/office/drawing/2014/main" xmlns="" id="{141EA4CD-09BC-FCA8-2D16-E146079229EC}"/>
              </a:ext>
            </a:extLst>
          </p:cNvPr>
          <p:cNvSpPr txBox="1"/>
          <p:nvPr/>
        </p:nvSpPr>
        <p:spPr>
          <a:xfrm>
            <a:off x="3840050" y="7696367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5" name="Textfeld 104">
            <a:extLst>
              <a:ext uri="{FF2B5EF4-FFF2-40B4-BE49-F238E27FC236}">
                <a16:creationId xmlns:a16="http://schemas.microsoft.com/office/drawing/2014/main" xmlns="" id="{048B679C-E57D-68B9-F03E-D39F115C3CDE}"/>
              </a:ext>
            </a:extLst>
          </p:cNvPr>
          <p:cNvSpPr txBox="1"/>
          <p:nvPr/>
        </p:nvSpPr>
        <p:spPr>
          <a:xfrm rot="16200000">
            <a:off x="3184394" y="6995184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8" name="Textfeld 107">
            <a:extLst>
              <a:ext uri="{FF2B5EF4-FFF2-40B4-BE49-F238E27FC236}">
                <a16:creationId xmlns:a16="http://schemas.microsoft.com/office/drawing/2014/main" xmlns="" id="{1B14E0D2-A0F0-52B3-8F2A-CDDF3CFBCB38}"/>
              </a:ext>
            </a:extLst>
          </p:cNvPr>
          <p:cNvSpPr txBox="1"/>
          <p:nvPr/>
        </p:nvSpPr>
        <p:spPr>
          <a:xfrm>
            <a:off x="3852328" y="9620898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09" name="Textfeld 108">
            <a:extLst>
              <a:ext uri="{FF2B5EF4-FFF2-40B4-BE49-F238E27FC236}">
                <a16:creationId xmlns:a16="http://schemas.microsoft.com/office/drawing/2014/main" xmlns="" id="{BD7290CB-FE5A-7B30-6053-D9BC918E26CC}"/>
              </a:ext>
            </a:extLst>
          </p:cNvPr>
          <p:cNvSpPr txBox="1"/>
          <p:nvPr/>
        </p:nvSpPr>
        <p:spPr>
          <a:xfrm rot="16200000">
            <a:off x="3196672" y="8919715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0" name="Textfeld 109">
            <a:extLst>
              <a:ext uri="{FF2B5EF4-FFF2-40B4-BE49-F238E27FC236}">
                <a16:creationId xmlns:a16="http://schemas.microsoft.com/office/drawing/2014/main" xmlns="" id="{EFA3F686-F9F3-1188-97F4-E897DA72FB3A}"/>
              </a:ext>
            </a:extLst>
          </p:cNvPr>
          <p:cNvSpPr txBox="1"/>
          <p:nvPr/>
        </p:nvSpPr>
        <p:spPr>
          <a:xfrm>
            <a:off x="3849769" y="11551111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1" name="Textfeld 110">
            <a:extLst>
              <a:ext uri="{FF2B5EF4-FFF2-40B4-BE49-F238E27FC236}">
                <a16:creationId xmlns:a16="http://schemas.microsoft.com/office/drawing/2014/main" xmlns="" id="{4709B30B-9441-936E-1642-1994A18D9D4A}"/>
              </a:ext>
            </a:extLst>
          </p:cNvPr>
          <p:cNvSpPr txBox="1"/>
          <p:nvPr/>
        </p:nvSpPr>
        <p:spPr>
          <a:xfrm rot="16200000">
            <a:off x="3194113" y="10849928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xmlns="" id="{3DEC5038-5F67-0F60-383F-D2B75D66BEC7}"/>
              </a:ext>
            </a:extLst>
          </p:cNvPr>
          <p:cNvSpPr txBox="1"/>
          <p:nvPr/>
        </p:nvSpPr>
        <p:spPr>
          <a:xfrm>
            <a:off x="3855946" y="13491094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xmlns="" id="{DF3E1DF4-750F-0F8B-905E-D42F5DE97B84}"/>
              </a:ext>
            </a:extLst>
          </p:cNvPr>
          <p:cNvSpPr txBox="1"/>
          <p:nvPr/>
        </p:nvSpPr>
        <p:spPr>
          <a:xfrm rot="16200000">
            <a:off x="3200290" y="12789911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xmlns="" id="{6024AE4F-93ED-C50D-C6F9-BA4C5FD89C0C}"/>
              </a:ext>
            </a:extLst>
          </p:cNvPr>
          <p:cNvSpPr txBox="1"/>
          <p:nvPr/>
        </p:nvSpPr>
        <p:spPr>
          <a:xfrm>
            <a:off x="3855875" y="15422914"/>
            <a:ext cx="326852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xmlns="" id="{FE761E38-5556-8166-EA07-0D835F458BCE}"/>
              </a:ext>
            </a:extLst>
          </p:cNvPr>
          <p:cNvSpPr txBox="1"/>
          <p:nvPr/>
        </p:nvSpPr>
        <p:spPr>
          <a:xfrm rot="16200000">
            <a:off x="3200219" y="14721731"/>
            <a:ext cx="11715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ead </a:t>
            </a:r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ount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16" name="Textfeld 115">
            <a:extLst>
              <a:ext uri="{FF2B5EF4-FFF2-40B4-BE49-F238E27FC236}">
                <a16:creationId xmlns:a16="http://schemas.microsoft.com/office/drawing/2014/main" xmlns="" id="{7F8A8251-A194-7D59-889D-9FEA674DD03A}"/>
              </a:ext>
            </a:extLst>
          </p:cNvPr>
          <p:cNvSpPr txBox="1"/>
          <p:nvPr/>
        </p:nvSpPr>
        <p:spPr>
          <a:xfrm>
            <a:off x="1880226" y="328439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16</a:t>
            </a:r>
            <a:endParaRPr lang="de-AT" b="1" dirty="0"/>
          </a:p>
        </p:txBody>
      </p:sp>
      <p:sp>
        <p:nvSpPr>
          <p:cNvPr id="117" name="Textfeld 116">
            <a:extLst>
              <a:ext uri="{FF2B5EF4-FFF2-40B4-BE49-F238E27FC236}">
                <a16:creationId xmlns:a16="http://schemas.microsoft.com/office/drawing/2014/main" xmlns="" id="{592734A0-DB43-3A49-EF67-633E3A96F7A8}"/>
              </a:ext>
            </a:extLst>
          </p:cNvPr>
          <p:cNvSpPr txBox="1"/>
          <p:nvPr/>
        </p:nvSpPr>
        <p:spPr>
          <a:xfrm>
            <a:off x="1880226" y="2229110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40</a:t>
            </a:r>
          </a:p>
        </p:txBody>
      </p:sp>
      <p:sp>
        <p:nvSpPr>
          <p:cNvPr id="118" name="Textfeld 117">
            <a:extLst>
              <a:ext uri="{FF2B5EF4-FFF2-40B4-BE49-F238E27FC236}">
                <a16:creationId xmlns:a16="http://schemas.microsoft.com/office/drawing/2014/main" xmlns="" id="{EA83F00A-DB94-55B9-CFA6-55DF35CB5FD5}"/>
              </a:ext>
            </a:extLst>
          </p:cNvPr>
          <p:cNvSpPr txBox="1"/>
          <p:nvPr/>
        </p:nvSpPr>
        <p:spPr>
          <a:xfrm>
            <a:off x="1880226" y="4203492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42</a:t>
            </a:r>
          </a:p>
        </p:txBody>
      </p:sp>
      <p:sp>
        <p:nvSpPr>
          <p:cNvPr id="119" name="Textfeld 118">
            <a:extLst>
              <a:ext uri="{FF2B5EF4-FFF2-40B4-BE49-F238E27FC236}">
                <a16:creationId xmlns:a16="http://schemas.microsoft.com/office/drawing/2014/main" xmlns="" id="{E028E562-FFFE-B41F-1FB7-F39CCFC10B98}"/>
              </a:ext>
            </a:extLst>
          </p:cNvPr>
          <p:cNvSpPr txBox="1"/>
          <p:nvPr/>
        </p:nvSpPr>
        <p:spPr>
          <a:xfrm>
            <a:off x="1880226" y="6096056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45</a:t>
            </a:r>
          </a:p>
        </p:txBody>
      </p:sp>
      <p:sp>
        <p:nvSpPr>
          <p:cNvPr id="120" name="Textfeld 119">
            <a:extLst>
              <a:ext uri="{FF2B5EF4-FFF2-40B4-BE49-F238E27FC236}">
                <a16:creationId xmlns:a16="http://schemas.microsoft.com/office/drawing/2014/main" xmlns="" id="{CFAF2CA7-C7C8-59F7-724F-F3511BE5A864}"/>
              </a:ext>
            </a:extLst>
          </p:cNvPr>
          <p:cNvSpPr txBox="1"/>
          <p:nvPr/>
        </p:nvSpPr>
        <p:spPr>
          <a:xfrm>
            <a:off x="1880226" y="8063702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51</a:t>
            </a:r>
          </a:p>
        </p:txBody>
      </p:sp>
      <p:sp>
        <p:nvSpPr>
          <p:cNvPr id="121" name="Textfeld 120">
            <a:extLst>
              <a:ext uri="{FF2B5EF4-FFF2-40B4-BE49-F238E27FC236}">
                <a16:creationId xmlns:a16="http://schemas.microsoft.com/office/drawing/2014/main" xmlns="" id="{FC124919-16FA-7524-26DF-52FBCF37D0C6}"/>
              </a:ext>
            </a:extLst>
          </p:cNvPr>
          <p:cNvSpPr txBox="1"/>
          <p:nvPr/>
        </p:nvSpPr>
        <p:spPr>
          <a:xfrm>
            <a:off x="1880226" y="9984488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65</a:t>
            </a: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xmlns="" id="{A7F3C120-90F3-F41A-A0FD-A17FA5CB7E32}"/>
              </a:ext>
            </a:extLst>
          </p:cNvPr>
          <p:cNvSpPr txBox="1"/>
          <p:nvPr/>
        </p:nvSpPr>
        <p:spPr>
          <a:xfrm>
            <a:off x="1880226" y="11928704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71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xmlns="" id="{F46CC9BB-9123-93A3-4662-9D0175672AEE}"/>
              </a:ext>
            </a:extLst>
          </p:cNvPr>
          <p:cNvSpPr txBox="1"/>
          <p:nvPr/>
        </p:nvSpPr>
        <p:spPr>
          <a:xfrm>
            <a:off x="1880226" y="13872920"/>
            <a:ext cx="333926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1600" b="1" dirty="0">
                <a:latin typeface="Consolas" panose="020B0609020204030204" pitchFamily="49" charset="0"/>
              </a:rPr>
              <a:t>SAMPLE ID078</a:t>
            </a:r>
          </a:p>
        </p:txBody>
      </p:sp>
      <p:pic>
        <p:nvPicPr>
          <p:cNvPr id="132" name="Grafik 131" descr="Ein Bild, das Text, Reihe, Screenshot, Schrift enthält.&#10;&#10;Automatisch generierte Beschreibung">
            <a:extLst>
              <a:ext uri="{FF2B5EF4-FFF2-40B4-BE49-F238E27FC236}">
                <a16:creationId xmlns:a16="http://schemas.microsoft.com/office/drawing/2014/main" xmlns="" id="{310A52E4-CE42-2C3B-204D-DCD246EA8656}"/>
              </a:ext>
            </a:extLst>
          </p:cNvPr>
          <p:cNvPicPr>
            <a:picLocks noChangeAspect="1"/>
          </p:cNvPicPr>
          <p:nvPr/>
        </p:nvPicPr>
        <p:blipFill>
          <a:blip r:embed="rId13" cstate="print">
            <a:grayscl/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387" y="12307287"/>
            <a:ext cx="3250233" cy="1188000"/>
          </a:xfrm>
          <a:prstGeom prst="rect">
            <a:avLst/>
          </a:prstGeom>
        </p:spPr>
      </p:pic>
      <p:pic>
        <p:nvPicPr>
          <p:cNvPr id="133" name="Grafik 132" descr="Ein Bild, das Text, Reihe, Screenshot, Schrift enthält.&#10;&#10;Automatisch generierte Beschreibung">
            <a:extLst>
              <a:ext uri="{FF2B5EF4-FFF2-40B4-BE49-F238E27FC236}">
                <a16:creationId xmlns:a16="http://schemas.microsoft.com/office/drawing/2014/main" xmlns="" id="{627E6BFD-4079-E1EE-AEA5-76B3DC4B70BA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33" y="10352195"/>
            <a:ext cx="3250233" cy="1188000"/>
          </a:xfrm>
          <a:prstGeom prst="rect">
            <a:avLst/>
          </a:prstGeom>
        </p:spPr>
      </p:pic>
      <p:pic>
        <p:nvPicPr>
          <p:cNvPr id="135" name="Grafik 134" descr="Ein Bild, das Text, Reihe, Schrift, Diagramm enthält.&#10;&#10;Automatisch generierte Beschreibung">
            <a:extLst>
              <a:ext uri="{FF2B5EF4-FFF2-40B4-BE49-F238E27FC236}">
                <a16:creationId xmlns:a16="http://schemas.microsoft.com/office/drawing/2014/main" xmlns="" id="{8152F9A4-CDAD-CE04-0032-06C8404E5A34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248" y="6500701"/>
            <a:ext cx="3250239" cy="1188000"/>
          </a:xfrm>
          <a:prstGeom prst="rect">
            <a:avLst/>
          </a:prstGeom>
        </p:spPr>
      </p:pic>
      <p:pic>
        <p:nvPicPr>
          <p:cNvPr id="137" name="Grafik 136" descr="Ein Bild, das Text, Reihe, Screenshot, Schrift enthält.&#10;&#10;Automatisch generierte Beschreibung">
            <a:extLst>
              <a:ext uri="{FF2B5EF4-FFF2-40B4-BE49-F238E27FC236}">
                <a16:creationId xmlns:a16="http://schemas.microsoft.com/office/drawing/2014/main" xmlns="" id="{BF8DEC6E-77F0-447F-3FD9-386E94E0137B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387" y="2626077"/>
            <a:ext cx="3250239" cy="1188000"/>
          </a:xfrm>
          <a:prstGeom prst="rect">
            <a:avLst/>
          </a:prstGeom>
        </p:spPr>
      </p:pic>
      <p:pic>
        <p:nvPicPr>
          <p:cNvPr id="138" name="Grafik 137" descr="Ein Bild, das Text, Reihe, Schrift, Screenshot enthält.&#10;&#10;Automatisch generierte Beschreibung">
            <a:extLst>
              <a:ext uri="{FF2B5EF4-FFF2-40B4-BE49-F238E27FC236}">
                <a16:creationId xmlns:a16="http://schemas.microsoft.com/office/drawing/2014/main" xmlns="" id="{16252424-273C-F778-8D80-5C0E79207338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387" y="732310"/>
            <a:ext cx="3250239" cy="1188000"/>
          </a:xfrm>
          <a:prstGeom prst="rect">
            <a:avLst/>
          </a:prstGeom>
        </p:spPr>
      </p:pic>
      <p:pic>
        <p:nvPicPr>
          <p:cNvPr id="139" name="Grafik 138" descr="Ein Bild, das Text, Reihe, Schrift, Screenshot enthält.&#10;&#10;Automatisch generierte Beschreibung">
            <a:extLst>
              <a:ext uri="{FF2B5EF4-FFF2-40B4-BE49-F238E27FC236}">
                <a16:creationId xmlns:a16="http://schemas.microsoft.com/office/drawing/2014/main" xmlns="" id="{31C64126-B8C0-6E3A-F826-CDCCF94235C4}"/>
              </a:ext>
            </a:extLst>
          </p:cNvPr>
          <p:cNvPicPr>
            <a:picLocks noChangeAspect="1"/>
          </p:cNvPicPr>
          <p:nvPr/>
        </p:nvPicPr>
        <p:blipFill>
          <a:blip r:embed="rId1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387" y="14249419"/>
            <a:ext cx="3250239" cy="1188000"/>
          </a:xfrm>
          <a:prstGeom prst="rect">
            <a:avLst/>
          </a:prstGeom>
        </p:spPr>
      </p:pic>
      <p:pic>
        <p:nvPicPr>
          <p:cNvPr id="141" name="Grafik 140" descr="Ein Bild, das Text, Reihe, Screenshot, Schrift enthält.&#10;&#10;Automatisch generierte Beschreibung">
            <a:extLst>
              <a:ext uri="{FF2B5EF4-FFF2-40B4-BE49-F238E27FC236}">
                <a16:creationId xmlns:a16="http://schemas.microsoft.com/office/drawing/2014/main" xmlns="" id="{73457BE7-7579-117C-BC62-38FA653C09B3}"/>
              </a:ext>
            </a:extLst>
          </p:cNvPr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33" y="8441131"/>
            <a:ext cx="3250240" cy="1188000"/>
          </a:xfrm>
          <a:prstGeom prst="rect">
            <a:avLst/>
          </a:prstGeom>
        </p:spPr>
      </p:pic>
      <p:sp>
        <p:nvSpPr>
          <p:cNvPr id="142" name="Textfeld 141">
            <a:extLst>
              <a:ext uri="{FF2B5EF4-FFF2-40B4-BE49-F238E27FC236}">
                <a16:creationId xmlns:a16="http://schemas.microsoft.com/office/drawing/2014/main" xmlns="" id="{AFA55AFB-1B67-B505-E74E-81E0F440E351}"/>
              </a:ext>
            </a:extLst>
          </p:cNvPr>
          <p:cNvSpPr txBox="1"/>
          <p:nvPr/>
        </p:nvSpPr>
        <p:spPr>
          <a:xfrm>
            <a:off x="227292" y="1922714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43" name="Textfeld 142">
            <a:extLst>
              <a:ext uri="{FF2B5EF4-FFF2-40B4-BE49-F238E27FC236}">
                <a16:creationId xmlns:a16="http://schemas.microsoft.com/office/drawing/2014/main" xmlns="" id="{75AB651C-7DD5-79D7-4189-1871359F6750}"/>
              </a:ext>
            </a:extLst>
          </p:cNvPr>
          <p:cNvSpPr txBox="1"/>
          <p:nvPr/>
        </p:nvSpPr>
        <p:spPr>
          <a:xfrm rot="16200000">
            <a:off x="-478534" y="1210895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46" name="Textfeld 145">
            <a:extLst>
              <a:ext uri="{FF2B5EF4-FFF2-40B4-BE49-F238E27FC236}">
                <a16:creationId xmlns:a16="http://schemas.microsoft.com/office/drawing/2014/main" xmlns="" id="{51B4CB83-911A-5E21-6301-597D213ACA80}"/>
              </a:ext>
            </a:extLst>
          </p:cNvPr>
          <p:cNvSpPr txBox="1"/>
          <p:nvPr/>
        </p:nvSpPr>
        <p:spPr>
          <a:xfrm>
            <a:off x="227291" y="3829323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47" name="Textfeld 146">
            <a:extLst>
              <a:ext uri="{FF2B5EF4-FFF2-40B4-BE49-F238E27FC236}">
                <a16:creationId xmlns:a16="http://schemas.microsoft.com/office/drawing/2014/main" xmlns="" id="{4488FE14-3D56-435F-AD5E-3759E112CFED}"/>
              </a:ext>
            </a:extLst>
          </p:cNvPr>
          <p:cNvSpPr txBox="1"/>
          <p:nvPr/>
        </p:nvSpPr>
        <p:spPr>
          <a:xfrm rot="16200000">
            <a:off x="-478535" y="3117504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0" name="Textfeld 149">
            <a:extLst>
              <a:ext uri="{FF2B5EF4-FFF2-40B4-BE49-F238E27FC236}">
                <a16:creationId xmlns:a16="http://schemas.microsoft.com/office/drawing/2014/main" xmlns="" id="{4823593B-863C-5557-F774-BA26275F239C}"/>
              </a:ext>
            </a:extLst>
          </p:cNvPr>
          <p:cNvSpPr txBox="1"/>
          <p:nvPr/>
        </p:nvSpPr>
        <p:spPr>
          <a:xfrm>
            <a:off x="227291" y="5773539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1" name="Textfeld 150">
            <a:extLst>
              <a:ext uri="{FF2B5EF4-FFF2-40B4-BE49-F238E27FC236}">
                <a16:creationId xmlns:a16="http://schemas.microsoft.com/office/drawing/2014/main" xmlns="" id="{3B2ECA27-1335-23F4-F2D1-C0030AEBB7A2}"/>
              </a:ext>
            </a:extLst>
          </p:cNvPr>
          <p:cNvSpPr txBox="1"/>
          <p:nvPr/>
        </p:nvSpPr>
        <p:spPr>
          <a:xfrm rot="16200000">
            <a:off x="-478535" y="5061720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2" name="Textfeld 151">
            <a:extLst>
              <a:ext uri="{FF2B5EF4-FFF2-40B4-BE49-F238E27FC236}">
                <a16:creationId xmlns:a16="http://schemas.microsoft.com/office/drawing/2014/main" xmlns="" id="{2D9FF839-547F-0122-C464-2CC47FE089BD}"/>
              </a:ext>
            </a:extLst>
          </p:cNvPr>
          <p:cNvSpPr txBox="1"/>
          <p:nvPr/>
        </p:nvSpPr>
        <p:spPr>
          <a:xfrm>
            <a:off x="227291" y="7698831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3" name="Textfeld 152">
            <a:extLst>
              <a:ext uri="{FF2B5EF4-FFF2-40B4-BE49-F238E27FC236}">
                <a16:creationId xmlns:a16="http://schemas.microsoft.com/office/drawing/2014/main" xmlns="" id="{AFF77C22-C118-17DB-5E9F-0415B85AA6F5}"/>
              </a:ext>
            </a:extLst>
          </p:cNvPr>
          <p:cNvSpPr txBox="1"/>
          <p:nvPr/>
        </p:nvSpPr>
        <p:spPr>
          <a:xfrm rot="16200000">
            <a:off x="-478535" y="6987012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4" name="Textfeld 153">
            <a:extLst>
              <a:ext uri="{FF2B5EF4-FFF2-40B4-BE49-F238E27FC236}">
                <a16:creationId xmlns:a16="http://schemas.microsoft.com/office/drawing/2014/main" xmlns="" id="{41F6D349-F8D6-4785-33E5-BC9082CF8D25}"/>
              </a:ext>
            </a:extLst>
          </p:cNvPr>
          <p:cNvSpPr txBox="1"/>
          <p:nvPr/>
        </p:nvSpPr>
        <p:spPr>
          <a:xfrm>
            <a:off x="230342" y="9626013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5" name="Textfeld 154">
            <a:extLst>
              <a:ext uri="{FF2B5EF4-FFF2-40B4-BE49-F238E27FC236}">
                <a16:creationId xmlns:a16="http://schemas.microsoft.com/office/drawing/2014/main" xmlns="" id="{79B3950F-44C4-9331-896A-F65EE407D9D0}"/>
              </a:ext>
            </a:extLst>
          </p:cNvPr>
          <p:cNvSpPr txBox="1"/>
          <p:nvPr/>
        </p:nvSpPr>
        <p:spPr>
          <a:xfrm rot="16200000">
            <a:off x="-475484" y="8914194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6" name="Textfeld 155">
            <a:extLst>
              <a:ext uri="{FF2B5EF4-FFF2-40B4-BE49-F238E27FC236}">
                <a16:creationId xmlns:a16="http://schemas.microsoft.com/office/drawing/2014/main" xmlns="" id="{F52415A1-13F5-F0C4-C62F-381D3CCE0619}"/>
              </a:ext>
            </a:extLst>
          </p:cNvPr>
          <p:cNvSpPr txBox="1"/>
          <p:nvPr/>
        </p:nvSpPr>
        <p:spPr>
          <a:xfrm>
            <a:off x="227291" y="11551111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7" name="Textfeld 156">
            <a:extLst>
              <a:ext uri="{FF2B5EF4-FFF2-40B4-BE49-F238E27FC236}">
                <a16:creationId xmlns:a16="http://schemas.microsoft.com/office/drawing/2014/main" xmlns="" id="{13DB192E-AEAB-79B8-AD07-8E1149312C9B}"/>
              </a:ext>
            </a:extLst>
          </p:cNvPr>
          <p:cNvSpPr txBox="1"/>
          <p:nvPr/>
        </p:nvSpPr>
        <p:spPr>
          <a:xfrm rot="16200000">
            <a:off x="-478535" y="10839292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8" name="Textfeld 157">
            <a:extLst>
              <a:ext uri="{FF2B5EF4-FFF2-40B4-BE49-F238E27FC236}">
                <a16:creationId xmlns:a16="http://schemas.microsoft.com/office/drawing/2014/main" xmlns="" id="{0CE230ED-4F66-00EA-CA33-8BBC24393AC8}"/>
              </a:ext>
            </a:extLst>
          </p:cNvPr>
          <p:cNvSpPr txBox="1"/>
          <p:nvPr/>
        </p:nvSpPr>
        <p:spPr>
          <a:xfrm>
            <a:off x="227291" y="13491094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59" name="Textfeld 158">
            <a:extLst>
              <a:ext uri="{FF2B5EF4-FFF2-40B4-BE49-F238E27FC236}">
                <a16:creationId xmlns:a16="http://schemas.microsoft.com/office/drawing/2014/main" xmlns="" id="{6502D331-8975-8529-B7F9-AA8BFD2F94E4}"/>
              </a:ext>
            </a:extLst>
          </p:cNvPr>
          <p:cNvSpPr txBox="1"/>
          <p:nvPr/>
        </p:nvSpPr>
        <p:spPr>
          <a:xfrm rot="16200000">
            <a:off x="-478535" y="12779275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60" name="Textfeld 159">
            <a:extLst>
              <a:ext uri="{FF2B5EF4-FFF2-40B4-BE49-F238E27FC236}">
                <a16:creationId xmlns:a16="http://schemas.microsoft.com/office/drawing/2014/main" xmlns="" id="{29994C4E-268D-007B-C221-51BCD34AD1D9}"/>
              </a:ext>
            </a:extLst>
          </p:cNvPr>
          <p:cNvSpPr txBox="1"/>
          <p:nvPr/>
        </p:nvSpPr>
        <p:spPr>
          <a:xfrm>
            <a:off x="227291" y="15435311"/>
            <a:ext cx="32523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 err="1">
                <a:latin typeface="Consolas" panose="020B0609020204030204" pitchFamily="49" charset="0"/>
                <a:cs typeface="Arial" panose="020B0604020202020204" pitchFamily="34" charset="0"/>
              </a:rPr>
              <a:t>Chromosomes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sp>
        <p:nvSpPr>
          <p:cNvPr id="161" name="Textfeld 160">
            <a:extLst>
              <a:ext uri="{FF2B5EF4-FFF2-40B4-BE49-F238E27FC236}">
                <a16:creationId xmlns:a16="http://schemas.microsoft.com/office/drawing/2014/main" xmlns="" id="{52BF61CC-D6D4-51DF-0D16-B33E8BD14DE0}"/>
              </a:ext>
            </a:extLst>
          </p:cNvPr>
          <p:cNvSpPr txBox="1"/>
          <p:nvPr/>
        </p:nvSpPr>
        <p:spPr>
          <a:xfrm rot="16200000">
            <a:off x="-478535" y="14723492"/>
            <a:ext cx="11880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Log</a:t>
            </a:r>
            <a:r>
              <a:rPr lang="de-AT" sz="900" baseline="-25000" dirty="0">
                <a:latin typeface="Consolas" panose="020B0609020204030204" pitchFamily="49" charset="0"/>
                <a:cs typeface="Arial" panose="020B0604020202020204" pitchFamily="34" charset="0"/>
              </a:rPr>
              <a:t>2</a:t>
            </a:r>
            <a:r>
              <a:rPr lang="de-AT" sz="900" dirty="0">
                <a:latin typeface="Consolas" panose="020B0609020204030204" pitchFamily="49" charset="0"/>
                <a:cs typeface="Arial" panose="020B0604020202020204" pitchFamily="34" charset="0"/>
              </a:rPr>
              <a:t>ratio</a:t>
            </a:r>
            <a:endParaRPr lang="de-AT" sz="800" dirty="0">
              <a:latin typeface="Consolas" panose="020B0609020204030204" pitchFamily="49" charset="0"/>
              <a:cs typeface="Arial" panose="020B0604020202020204" pitchFamily="34" charset="0"/>
            </a:endParaRPr>
          </a:p>
        </p:txBody>
      </p:sp>
      <p:cxnSp>
        <p:nvCxnSpPr>
          <p:cNvPr id="162" name="Gerade Verbindung 81">
            <a:extLst>
              <a:ext uri="{FF2B5EF4-FFF2-40B4-BE49-F238E27FC236}">
                <a16:creationId xmlns:a16="http://schemas.microsoft.com/office/drawing/2014/main" xmlns="" id="{0C1DA768-0DED-2D1E-7573-43C5EF7440B4}"/>
              </a:ext>
            </a:extLst>
          </p:cNvPr>
          <p:cNvCxnSpPr>
            <a:cxnSpLocks/>
          </p:cNvCxnSpPr>
          <p:nvPr/>
        </p:nvCxnSpPr>
        <p:spPr>
          <a:xfrm flipH="1">
            <a:off x="263377" y="3268067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Gerade Verbindung 81">
            <a:extLst>
              <a:ext uri="{FF2B5EF4-FFF2-40B4-BE49-F238E27FC236}">
                <a16:creationId xmlns:a16="http://schemas.microsoft.com/office/drawing/2014/main" xmlns="" id="{166E61D1-CC32-FAAE-9FF8-1164D56437F9}"/>
              </a:ext>
            </a:extLst>
          </p:cNvPr>
          <p:cNvCxnSpPr>
            <a:cxnSpLocks/>
          </p:cNvCxnSpPr>
          <p:nvPr/>
        </p:nvCxnSpPr>
        <p:spPr>
          <a:xfrm flipH="1">
            <a:off x="268566" y="5228158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Gerade Verbindung 81">
            <a:extLst>
              <a:ext uri="{FF2B5EF4-FFF2-40B4-BE49-F238E27FC236}">
                <a16:creationId xmlns:a16="http://schemas.microsoft.com/office/drawing/2014/main" xmlns="" id="{B07F3611-9EBC-F54A-91A2-14917CEEB020}"/>
              </a:ext>
            </a:extLst>
          </p:cNvPr>
          <p:cNvCxnSpPr>
            <a:cxnSpLocks/>
          </p:cNvCxnSpPr>
          <p:nvPr/>
        </p:nvCxnSpPr>
        <p:spPr>
          <a:xfrm flipH="1">
            <a:off x="274569" y="7143799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Gerade Verbindung 81">
            <a:extLst>
              <a:ext uri="{FF2B5EF4-FFF2-40B4-BE49-F238E27FC236}">
                <a16:creationId xmlns:a16="http://schemas.microsoft.com/office/drawing/2014/main" xmlns="" id="{2376100E-A9E2-A9D2-426D-85D2C83353EE}"/>
              </a:ext>
            </a:extLst>
          </p:cNvPr>
          <p:cNvCxnSpPr>
            <a:cxnSpLocks/>
          </p:cNvCxnSpPr>
          <p:nvPr/>
        </p:nvCxnSpPr>
        <p:spPr>
          <a:xfrm flipH="1">
            <a:off x="274569" y="9081665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Gerade Verbindung 81">
            <a:extLst>
              <a:ext uri="{FF2B5EF4-FFF2-40B4-BE49-F238E27FC236}">
                <a16:creationId xmlns:a16="http://schemas.microsoft.com/office/drawing/2014/main" xmlns="" id="{857EB53C-8FA7-340B-371B-734E9E219ED7}"/>
              </a:ext>
            </a:extLst>
          </p:cNvPr>
          <p:cNvCxnSpPr>
            <a:cxnSpLocks/>
          </p:cNvCxnSpPr>
          <p:nvPr/>
        </p:nvCxnSpPr>
        <p:spPr>
          <a:xfrm flipH="1">
            <a:off x="280919" y="10994131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Gerade Verbindung 81">
            <a:extLst>
              <a:ext uri="{FF2B5EF4-FFF2-40B4-BE49-F238E27FC236}">
                <a16:creationId xmlns:a16="http://schemas.microsoft.com/office/drawing/2014/main" xmlns="" id="{A15FFA81-AC84-19FC-01B0-E11B2FDCE227}"/>
              </a:ext>
            </a:extLst>
          </p:cNvPr>
          <p:cNvCxnSpPr>
            <a:cxnSpLocks/>
          </p:cNvCxnSpPr>
          <p:nvPr/>
        </p:nvCxnSpPr>
        <p:spPr>
          <a:xfrm flipH="1">
            <a:off x="269032" y="12948889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Gerade Verbindung 81">
            <a:extLst>
              <a:ext uri="{FF2B5EF4-FFF2-40B4-BE49-F238E27FC236}">
                <a16:creationId xmlns:a16="http://schemas.microsoft.com/office/drawing/2014/main" xmlns="" id="{D0443850-33A2-4543-F691-8AF9F3F7D73F}"/>
              </a:ext>
            </a:extLst>
          </p:cNvPr>
          <p:cNvCxnSpPr>
            <a:cxnSpLocks/>
          </p:cNvCxnSpPr>
          <p:nvPr/>
        </p:nvCxnSpPr>
        <p:spPr>
          <a:xfrm flipH="1">
            <a:off x="269727" y="14888913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Gerade Verbindung 81">
            <a:extLst>
              <a:ext uri="{FF2B5EF4-FFF2-40B4-BE49-F238E27FC236}">
                <a16:creationId xmlns:a16="http://schemas.microsoft.com/office/drawing/2014/main" xmlns="" id="{51EE7AA3-83DA-DAF0-637D-44C7ABDC9DDB}"/>
              </a:ext>
            </a:extLst>
          </p:cNvPr>
          <p:cNvCxnSpPr>
            <a:cxnSpLocks/>
          </p:cNvCxnSpPr>
          <p:nvPr/>
        </p:nvCxnSpPr>
        <p:spPr>
          <a:xfrm flipH="1">
            <a:off x="269922" y="1373747"/>
            <a:ext cx="3186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1" name="Gerade Verbindung 40">
            <a:extLst>
              <a:ext uri="{FF2B5EF4-FFF2-40B4-BE49-F238E27FC236}">
                <a16:creationId xmlns:a16="http://schemas.microsoft.com/office/drawing/2014/main" xmlns="" id="{3275829D-C7B5-DF67-BCA0-4D4F75C62A57}"/>
              </a:ext>
            </a:extLst>
          </p:cNvPr>
          <p:cNvCxnSpPr>
            <a:cxnSpLocks/>
          </p:cNvCxnSpPr>
          <p:nvPr/>
        </p:nvCxnSpPr>
        <p:spPr>
          <a:xfrm flipH="1">
            <a:off x="3906834" y="5232382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Gerade Verbindung 40">
            <a:extLst>
              <a:ext uri="{FF2B5EF4-FFF2-40B4-BE49-F238E27FC236}">
                <a16:creationId xmlns:a16="http://schemas.microsoft.com/office/drawing/2014/main" xmlns="" id="{027C7710-3F5C-216B-003D-68D4EE4C43B3}"/>
              </a:ext>
            </a:extLst>
          </p:cNvPr>
          <p:cNvCxnSpPr>
            <a:cxnSpLocks/>
          </p:cNvCxnSpPr>
          <p:nvPr/>
        </p:nvCxnSpPr>
        <p:spPr>
          <a:xfrm flipH="1">
            <a:off x="3906834" y="7122635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Gerade Verbindung 40">
            <a:extLst>
              <a:ext uri="{FF2B5EF4-FFF2-40B4-BE49-F238E27FC236}">
                <a16:creationId xmlns:a16="http://schemas.microsoft.com/office/drawing/2014/main" xmlns="" id="{6F6EEDB3-2FE3-5684-74AF-D85A4469198A}"/>
              </a:ext>
            </a:extLst>
          </p:cNvPr>
          <p:cNvCxnSpPr>
            <a:cxnSpLocks/>
          </p:cNvCxnSpPr>
          <p:nvPr/>
        </p:nvCxnSpPr>
        <p:spPr>
          <a:xfrm flipH="1">
            <a:off x="3906834" y="9100715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Gerade Verbindung 40">
            <a:extLst>
              <a:ext uri="{FF2B5EF4-FFF2-40B4-BE49-F238E27FC236}">
                <a16:creationId xmlns:a16="http://schemas.microsoft.com/office/drawing/2014/main" xmlns="" id="{D10FCEF2-C2A4-2DE7-A9F5-C66EA3AC627B}"/>
              </a:ext>
            </a:extLst>
          </p:cNvPr>
          <p:cNvCxnSpPr>
            <a:cxnSpLocks/>
          </p:cNvCxnSpPr>
          <p:nvPr/>
        </p:nvCxnSpPr>
        <p:spPr>
          <a:xfrm flipH="1">
            <a:off x="3906834" y="11083075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Gerade Verbindung 40">
            <a:extLst>
              <a:ext uri="{FF2B5EF4-FFF2-40B4-BE49-F238E27FC236}">
                <a16:creationId xmlns:a16="http://schemas.microsoft.com/office/drawing/2014/main" xmlns="" id="{EA9CAC88-3DEF-03F4-A2F6-7BA75521ED85}"/>
              </a:ext>
            </a:extLst>
          </p:cNvPr>
          <p:cNvCxnSpPr>
            <a:cxnSpLocks/>
          </p:cNvCxnSpPr>
          <p:nvPr/>
        </p:nvCxnSpPr>
        <p:spPr>
          <a:xfrm flipH="1">
            <a:off x="3906834" y="12989147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Gerade Verbindung 40">
            <a:extLst>
              <a:ext uri="{FF2B5EF4-FFF2-40B4-BE49-F238E27FC236}">
                <a16:creationId xmlns:a16="http://schemas.microsoft.com/office/drawing/2014/main" xmlns="" id="{C4F9F35A-54AA-C59D-A1BC-81E8A55EA7FA}"/>
              </a:ext>
            </a:extLst>
          </p:cNvPr>
          <p:cNvCxnSpPr>
            <a:cxnSpLocks/>
          </p:cNvCxnSpPr>
          <p:nvPr/>
        </p:nvCxnSpPr>
        <p:spPr>
          <a:xfrm flipH="1">
            <a:off x="3902608" y="14831724"/>
            <a:ext cx="3150000" cy="0"/>
          </a:xfrm>
          <a:prstGeom prst="line">
            <a:avLst/>
          </a:prstGeom>
          <a:ln>
            <a:solidFill>
              <a:schemeClr val="tx2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2026830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Benutzerdefiniert</PresentationFormat>
  <Paragraphs>42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ilvia</dc:creator>
  <cp:lastModifiedBy>Vivienne</cp:lastModifiedBy>
  <cp:revision>12</cp:revision>
  <dcterms:created xsi:type="dcterms:W3CDTF">2023-10-25T13:26:12Z</dcterms:created>
  <dcterms:modified xsi:type="dcterms:W3CDTF">2024-02-26T13:22:53Z</dcterms:modified>
</cp:coreProperties>
</file>